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80" r:id="rId5"/>
    <p:sldId id="273" r:id="rId6"/>
    <p:sldId id="272" r:id="rId7"/>
    <p:sldId id="278" r:id="rId8"/>
    <p:sldId id="279" r:id="rId9"/>
    <p:sldId id="281" r:id="rId10"/>
    <p:sldId id="282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50" d="100"/>
          <a:sy n="150" d="100"/>
        </p:scale>
        <p:origin x="1080" y="-27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ariv greenshpan" userId="04267bd6-eb40-4405-bb71-e4e8b5a7539f" providerId="ADAL" clId="{46E6BF90-D52F-4CFB-A15C-3DF35EC790DF}"/>
    <pc:docChg chg="custSel addSld modSld">
      <pc:chgData name="yariv greenshpan" userId="04267bd6-eb40-4405-bb71-e4e8b5a7539f" providerId="ADAL" clId="{46E6BF90-D52F-4CFB-A15C-3DF35EC790DF}" dt="2022-03-21T13:23:35.020" v="520" actId="20577"/>
      <pc:docMkLst>
        <pc:docMk/>
      </pc:docMkLst>
      <pc:sldChg chg="modSp">
        <pc:chgData name="yariv greenshpan" userId="04267bd6-eb40-4405-bb71-e4e8b5a7539f" providerId="ADAL" clId="{46E6BF90-D52F-4CFB-A15C-3DF35EC790DF}" dt="2022-03-21T13:23:35.020" v="520" actId="20577"/>
        <pc:sldMkLst>
          <pc:docMk/>
          <pc:sldMk cId="344118405" sldId="272"/>
        </pc:sldMkLst>
        <pc:spChg chg="mod">
          <ac:chgData name="yariv greenshpan" userId="04267bd6-eb40-4405-bb71-e4e8b5a7539f" providerId="ADAL" clId="{46E6BF90-D52F-4CFB-A15C-3DF35EC790DF}" dt="2022-03-21T13:23:35.020" v="520" actId="20577"/>
          <ac:spMkLst>
            <pc:docMk/>
            <pc:sldMk cId="344118405" sldId="272"/>
            <ac:spMk id="5" creationId="{00000000-0000-0000-0000-000000000000}"/>
          </ac:spMkLst>
        </pc:spChg>
      </pc:sldChg>
      <pc:sldChg chg="modSp">
        <pc:chgData name="yariv greenshpan" userId="04267bd6-eb40-4405-bb71-e4e8b5a7539f" providerId="ADAL" clId="{46E6BF90-D52F-4CFB-A15C-3DF35EC790DF}" dt="2022-03-15T11:32:34.549" v="374" actId="20577"/>
        <pc:sldMkLst>
          <pc:docMk/>
          <pc:sldMk cId="1411503484" sldId="273"/>
        </pc:sldMkLst>
        <pc:spChg chg="mod">
          <ac:chgData name="yariv greenshpan" userId="04267bd6-eb40-4405-bb71-e4e8b5a7539f" providerId="ADAL" clId="{46E6BF90-D52F-4CFB-A15C-3DF35EC790DF}" dt="2022-03-15T11:32:34.549" v="374" actId="20577"/>
          <ac:spMkLst>
            <pc:docMk/>
            <pc:sldMk cId="1411503484" sldId="273"/>
            <ac:spMk id="42" creationId="{00000000-0000-0000-0000-000000000000}"/>
          </ac:spMkLst>
        </pc:spChg>
      </pc:sldChg>
      <pc:sldChg chg="modSp">
        <pc:chgData name="yariv greenshpan" userId="04267bd6-eb40-4405-bb71-e4e8b5a7539f" providerId="ADAL" clId="{46E6BF90-D52F-4CFB-A15C-3DF35EC790DF}" dt="2022-03-15T11:32:25.208" v="368" actId="20577"/>
        <pc:sldMkLst>
          <pc:docMk/>
          <pc:sldMk cId="1837578986" sldId="278"/>
        </pc:sldMkLst>
        <pc:spChg chg="mod">
          <ac:chgData name="yariv greenshpan" userId="04267bd6-eb40-4405-bb71-e4e8b5a7539f" providerId="ADAL" clId="{46E6BF90-D52F-4CFB-A15C-3DF35EC790DF}" dt="2022-03-15T11:32:25.208" v="368" actId="20577"/>
          <ac:spMkLst>
            <pc:docMk/>
            <pc:sldMk cId="1837578986" sldId="278"/>
            <ac:spMk id="5" creationId="{00000000-0000-0000-0000-000000000000}"/>
          </ac:spMkLst>
        </pc:spChg>
      </pc:sldChg>
      <pc:sldChg chg="modSp">
        <pc:chgData name="yariv greenshpan" userId="04267bd6-eb40-4405-bb71-e4e8b5a7539f" providerId="ADAL" clId="{46E6BF90-D52F-4CFB-A15C-3DF35EC790DF}" dt="2022-03-15T11:32:18.984" v="365" actId="20577"/>
        <pc:sldMkLst>
          <pc:docMk/>
          <pc:sldMk cId="3803561595" sldId="279"/>
        </pc:sldMkLst>
        <pc:spChg chg="mod">
          <ac:chgData name="yariv greenshpan" userId="04267bd6-eb40-4405-bb71-e4e8b5a7539f" providerId="ADAL" clId="{46E6BF90-D52F-4CFB-A15C-3DF35EC790DF}" dt="2022-03-15T11:32:18.984" v="365" actId="20577"/>
          <ac:spMkLst>
            <pc:docMk/>
            <pc:sldMk cId="3803561595" sldId="279"/>
            <ac:spMk id="3" creationId="{8DA3DD7E-C779-4D57-91C2-6BD05DEF064C}"/>
          </ac:spMkLst>
        </pc:spChg>
      </pc:sldChg>
      <pc:sldChg chg="modSp">
        <pc:chgData name="yariv greenshpan" userId="04267bd6-eb40-4405-bb71-e4e8b5a7539f" providerId="ADAL" clId="{46E6BF90-D52F-4CFB-A15C-3DF35EC790DF}" dt="2022-03-15T11:32:50.837" v="377" actId="20577"/>
        <pc:sldMkLst>
          <pc:docMk/>
          <pc:sldMk cId="2907499100" sldId="280"/>
        </pc:sldMkLst>
        <pc:spChg chg="mod">
          <ac:chgData name="yariv greenshpan" userId="04267bd6-eb40-4405-bb71-e4e8b5a7539f" providerId="ADAL" clId="{46E6BF90-D52F-4CFB-A15C-3DF35EC790DF}" dt="2022-03-15T11:32:50.837" v="377" actId="20577"/>
          <ac:spMkLst>
            <pc:docMk/>
            <pc:sldMk cId="2907499100" sldId="280"/>
            <ac:spMk id="3" creationId="{03C47D20-E738-41DB-A3F8-30F10B482F8D}"/>
          </ac:spMkLst>
        </pc:spChg>
      </pc:sldChg>
      <pc:sldChg chg="addSp delSp modSp add">
        <pc:chgData name="yariv greenshpan" userId="04267bd6-eb40-4405-bb71-e4e8b5a7539f" providerId="ADAL" clId="{46E6BF90-D52F-4CFB-A15C-3DF35EC790DF}" dt="2022-03-15T11:32:14.424" v="362" actId="20577"/>
        <pc:sldMkLst>
          <pc:docMk/>
          <pc:sldMk cId="1243598662" sldId="281"/>
        </pc:sldMkLst>
        <pc:spChg chg="mod">
          <ac:chgData name="yariv greenshpan" userId="04267bd6-eb40-4405-bb71-e4e8b5a7539f" providerId="ADAL" clId="{46E6BF90-D52F-4CFB-A15C-3DF35EC790DF}" dt="2022-03-15T11:32:14.424" v="362" actId="20577"/>
          <ac:spMkLst>
            <pc:docMk/>
            <pc:sldMk cId="1243598662" sldId="281"/>
            <ac:spMk id="3" creationId="{8DA3DD7E-C779-4D57-91C2-6BD05DEF064C}"/>
          </ac:spMkLst>
        </pc:spChg>
        <pc:spChg chg="add mod">
          <ac:chgData name="yariv greenshpan" userId="04267bd6-eb40-4405-bb71-e4e8b5a7539f" providerId="ADAL" clId="{46E6BF90-D52F-4CFB-A15C-3DF35EC790DF}" dt="2022-03-14T11:24:54.588" v="241" actId="1076"/>
          <ac:spMkLst>
            <pc:docMk/>
            <pc:sldMk cId="1243598662" sldId="281"/>
            <ac:spMk id="22" creationId="{B77AF016-A50E-48BD-AD5E-2D16360FEE36}"/>
          </ac:spMkLst>
        </pc:spChg>
        <pc:spChg chg="add mod">
          <ac:chgData name="yariv greenshpan" userId="04267bd6-eb40-4405-bb71-e4e8b5a7539f" providerId="ADAL" clId="{46E6BF90-D52F-4CFB-A15C-3DF35EC790DF}" dt="2022-03-14T11:24:51.650" v="240" actId="1076"/>
          <ac:spMkLst>
            <pc:docMk/>
            <pc:sldMk cId="1243598662" sldId="281"/>
            <ac:spMk id="23" creationId="{D410667E-BFDC-41FF-BB02-073A0EB7F2C2}"/>
          </ac:spMkLst>
        </pc:spChg>
        <pc:spChg chg="add">
          <ac:chgData name="yariv greenshpan" userId="04267bd6-eb40-4405-bb71-e4e8b5a7539f" providerId="ADAL" clId="{46E6BF90-D52F-4CFB-A15C-3DF35EC790DF}" dt="2022-03-14T11:26:51.340" v="284"/>
          <ac:spMkLst>
            <pc:docMk/>
            <pc:sldMk cId="1243598662" sldId="281"/>
            <ac:spMk id="26" creationId="{04C04DDC-8D5D-4B07-857D-18E6F0EC2844}"/>
          </ac:spMkLst>
        </pc:spChg>
        <pc:spChg chg="add mod">
          <ac:chgData name="yariv greenshpan" userId="04267bd6-eb40-4405-bb71-e4e8b5a7539f" providerId="ADAL" clId="{46E6BF90-D52F-4CFB-A15C-3DF35EC790DF}" dt="2022-03-14T11:26:58.073" v="285" actId="1076"/>
          <ac:spMkLst>
            <pc:docMk/>
            <pc:sldMk cId="1243598662" sldId="281"/>
            <ac:spMk id="27" creationId="{1DF2D9E3-3D1A-4604-9446-AB6EE9106D8A}"/>
          </ac:spMkLst>
        </pc:spChg>
        <pc:spChg chg="add mod">
          <ac:chgData name="yariv greenshpan" userId="04267bd6-eb40-4405-bb71-e4e8b5a7539f" providerId="ADAL" clId="{46E6BF90-D52F-4CFB-A15C-3DF35EC790DF}" dt="2022-03-14T11:35:13.660" v="312" actId="1038"/>
          <ac:spMkLst>
            <pc:docMk/>
            <pc:sldMk cId="1243598662" sldId="281"/>
            <ac:spMk id="28" creationId="{97D1AD37-B5B7-4116-B57E-83F4EFD321D0}"/>
          </ac:spMkLst>
        </pc:spChg>
        <pc:spChg chg="add mod">
          <ac:chgData name="yariv greenshpan" userId="04267bd6-eb40-4405-bb71-e4e8b5a7539f" providerId="ADAL" clId="{46E6BF90-D52F-4CFB-A15C-3DF35EC790DF}" dt="2022-03-14T11:35:13.660" v="312" actId="1038"/>
          <ac:spMkLst>
            <pc:docMk/>
            <pc:sldMk cId="1243598662" sldId="281"/>
            <ac:spMk id="29" creationId="{2DE76CE7-0DDE-4C06-864A-868EB07B8205}"/>
          </ac:spMkLst>
        </pc:spChg>
        <pc:spChg chg="add mod">
          <ac:chgData name="yariv greenshpan" userId="04267bd6-eb40-4405-bb71-e4e8b5a7539f" providerId="ADAL" clId="{46E6BF90-D52F-4CFB-A15C-3DF35EC790DF}" dt="2022-03-14T11:35:13.660" v="312" actId="1038"/>
          <ac:spMkLst>
            <pc:docMk/>
            <pc:sldMk cId="1243598662" sldId="281"/>
            <ac:spMk id="30" creationId="{EB35C23D-46BE-47CA-BCA1-A4B645140830}"/>
          </ac:spMkLst>
        </pc:spChg>
        <pc:spChg chg="add mod">
          <ac:chgData name="yariv greenshpan" userId="04267bd6-eb40-4405-bb71-e4e8b5a7539f" providerId="ADAL" clId="{46E6BF90-D52F-4CFB-A15C-3DF35EC790DF}" dt="2022-03-14T11:35:13.660" v="312" actId="1038"/>
          <ac:spMkLst>
            <pc:docMk/>
            <pc:sldMk cId="1243598662" sldId="281"/>
            <ac:spMk id="31" creationId="{3CD9CA8D-C5BA-40ED-99DB-C1C7A86E63A7}"/>
          </ac:spMkLst>
        </pc:spChg>
        <pc:graphicFrameChg chg="del">
          <ac:chgData name="yariv greenshpan" userId="04267bd6-eb40-4405-bb71-e4e8b5a7539f" providerId="ADAL" clId="{46E6BF90-D52F-4CFB-A15C-3DF35EC790DF}" dt="2022-03-14T11:13:35.971" v="3" actId="478"/>
          <ac:graphicFrameMkLst>
            <pc:docMk/>
            <pc:sldMk cId="1243598662" sldId="281"/>
            <ac:graphicFrameMk id="2" creationId="{CDD61DC0-5C45-4B05-9A19-D6CD62F85E32}"/>
          </ac:graphicFrameMkLst>
        </pc:graphicFrameChg>
        <pc:picChg chg="add del mod">
          <ac:chgData name="yariv greenshpan" userId="04267bd6-eb40-4405-bb71-e4e8b5a7539f" providerId="ADAL" clId="{46E6BF90-D52F-4CFB-A15C-3DF35EC790DF}" dt="2022-03-14T11:22:26.912" v="114" actId="478"/>
          <ac:picMkLst>
            <pc:docMk/>
            <pc:sldMk cId="1243598662" sldId="281"/>
            <ac:picMk id="4" creationId="{0EAEF701-6CBB-4308-9AC3-FDD8861E9A9C}"/>
          </ac:picMkLst>
        </pc:picChg>
        <pc:picChg chg="add del mod">
          <ac:chgData name="yariv greenshpan" userId="04267bd6-eb40-4405-bb71-e4e8b5a7539f" providerId="ADAL" clId="{46E6BF90-D52F-4CFB-A15C-3DF35EC790DF}" dt="2022-03-15T11:31:10.439" v="353" actId="478"/>
          <ac:picMkLst>
            <pc:docMk/>
            <pc:sldMk cId="1243598662" sldId="281"/>
            <ac:picMk id="4" creationId="{B0561623-2671-4A3D-96FD-FA31C3348EB4}"/>
          </ac:picMkLst>
        </pc:picChg>
        <pc:picChg chg="add del mod">
          <ac:chgData name="yariv greenshpan" userId="04267bd6-eb40-4405-bb71-e4e8b5a7539f" providerId="ADAL" clId="{46E6BF90-D52F-4CFB-A15C-3DF35EC790DF}" dt="2022-03-14T11:22:26.912" v="114" actId="478"/>
          <ac:picMkLst>
            <pc:docMk/>
            <pc:sldMk cId="1243598662" sldId="281"/>
            <ac:picMk id="5" creationId="{A0DB4965-B1A7-41E4-A903-201ECEBCE922}"/>
          </ac:picMkLst>
        </pc:picChg>
        <pc:picChg chg="add del mod">
          <ac:chgData name="yariv greenshpan" userId="04267bd6-eb40-4405-bb71-e4e8b5a7539f" providerId="ADAL" clId="{46E6BF90-D52F-4CFB-A15C-3DF35EC790DF}" dt="2022-03-14T11:22:26.912" v="114" actId="478"/>
          <ac:picMkLst>
            <pc:docMk/>
            <pc:sldMk cId="1243598662" sldId="281"/>
            <ac:picMk id="6" creationId="{77024963-2C0F-4808-9118-33776D7C9061}"/>
          </ac:picMkLst>
        </pc:picChg>
        <pc:picChg chg="add del mod">
          <ac:chgData name="yariv greenshpan" userId="04267bd6-eb40-4405-bb71-e4e8b5a7539f" providerId="ADAL" clId="{46E6BF90-D52F-4CFB-A15C-3DF35EC790DF}" dt="2022-03-14T11:22:26.912" v="114" actId="478"/>
          <ac:picMkLst>
            <pc:docMk/>
            <pc:sldMk cId="1243598662" sldId="281"/>
            <ac:picMk id="7" creationId="{BE4B0B0B-C512-4AB3-AFE7-1493CA3F9478}"/>
          </ac:picMkLst>
        </pc:picChg>
        <pc:picChg chg="add del mod">
          <ac:chgData name="yariv greenshpan" userId="04267bd6-eb40-4405-bb71-e4e8b5a7539f" providerId="ADAL" clId="{46E6BF90-D52F-4CFB-A15C-3DF35EC790DF}" dt="2022-03-14T11:22:28.205" v="115" actId="478"/>
          <ac:picMkLst>
            <pc:docMk/>
            <pc:sldMk cId="1243598662" sldId="281"/>
            <ac:picMk id="8" creationId="{6E40EE38-F74F-451F-9165-B21021FD51D1}"/>
          </ac:picMkLst>
        </pc:picChg>
        <pc:picChg chg="add del mod">
          <ac:chgData name="yariv greenshpan" userId="04267bd6-eb40-4405-bb71-e4e8b5a7539f" providerId="ADAL" clId="{46E6BF90-D52F-4CFB-A15C-3DF35EC790DF}" dt="2022-03-14T11:22:28.205" v="115" actId="478"/>
          <ac:picMkLst>
            <pc:docMk/>
            <pc:sldMk cId="1243598662" sldId="281"/>
            <ac:picMk id="9" creationId="{62145739-FBD1-4D02-9245-2271DA62471C}"/>
          </ac:picMkLst>
        </pc:picChg>
        <pc:picChg chg="add del mod">
          <ac:chgData name="yariv greenshpan" userId="04267bd6-eb40-4405-bb71-e4e8b5a7539f" providerId="ADAL" clId="{46E6BF90-D52F-4CFB-A15C-3DF35EC790DF}" dt="2022-03-14T11:22:28.205" v="115" actId="478"/>
          <ac:picMkLst>
            <pc:docMk/>
            <pc:sldMk cId="1243598662" sldId="281"/>
            <ac:picMk id="10" creationId="{14D7504F-C07C-4161-8DC6-5C5C22159865}"/>
          </ac:picMkLst>
        </pc:picChg>
        <pc:picChg chg="add del mod">
          <ac:chgData name="yariv greenshpan" userId="04267bd6-eb40-4405-bb71-e4e8b5a7539f" providerId="ADAL" clId="{46E6BF90-D52F-4CFB-A15C-3DF35EC790DF}" dt="2022-03-14T11:22:28.205" v="115" actId="478"/>
          <ac:picMkLst>
            <pc:docMk/>
            <pc:sldMk cId="1243598662" sldId="281"/>
            <ac:picMk id="11" creationId="{8098AF28-10F6-48C8-A3FC-ABEA8EF17A00}"/>
          </ac:picMkLst>
        </pc:picChg>
        <pc:picChg chg="add mod">
          <ac:chgData name="yariv greenshpan" userId="04267bd6-eb40-4405-bb71-e4e8b5a7539f" providerId="ADAL" clId="{46E6BF90-D52F-4CFB-A15C-3DF35EC790DF}" dt="2022-03-14T11:25:44.653" v="276" actId="408"/>
          <ac:picMkLst>
            <pc:docMk/>
            <pc:sldMk cId="1243598662" sldId="281"/>
            <ac:picMk id="12" creationId="{BA4EE91D-8123-4E84-98E2-C77A4BB86072}"/>
          </ac:picMkLst>
        </pc:picChg>
        <pc:picChg chg="add mod">
          <ac:chgData name="yariv greenshpan" userId="04267bd6-eb40-4405-bb71-e4e8b5a7539f" providerId="ADAL" clId="{46E6BF90-D52F-4CFB-A15C-3DF35EC790DF}" dt="2022-03-14T11:25:44.653" v="276" actId="408"/>
          <ac:picMkLst>
            <pc:docMk/>
            <pc:sldMk cId="1243598662" sldId="281"/>
            <ac:picMk id="13" creationId="{DD77A827-13E6-4B65-AC77-48BFEB4CBCD8}"/>
          </ac:picMkLst>
        </pc:picChg>
        <pc:picChg chg="add mod">
          <ac:chgData name="yariv greenshpan" userId="04267bd6-eb40-4405-bb71-e4e8b5a7539f" providerId="ADAL" clId="{46E6BF90-D52F-4CFB-A15C-3DF35EC790DF}" dt="2022-03-14T11:25:44.653" v="276" actId="408"/>
          <ac:picMkLst>
            <pc:docMk/>
            <pc:sldMk cId="1243598662" sldId="281"/>
            <ac:picMk id="14" creationId="{FFC3F275-4896-4B3F-8644-3174E1787050}"/>
          </ac:picMkLst>
        </pc:picChg>
        <pc:picChg chg="add mod">
          <ac:chgData name="yariv greenshpan" userId="04267bd6-eb40-4405-bb71-e4e8b5a7539f" providerId="ADAL" clId="{46E6BF90-D52F-4CFB-A15C-3DF35EC790DF}" dt="2022-03-14T11:25:44.653" v="276" actId="408"/>
          <ac:picMkLst>
            <pc:docMk/>
            <pc:sldMk cId="1243598662" sldId="281"/>
            <ac:picMk id="15" creationId="{7EB4B8E0-7227-4CAC-A65D-F3F3645D1C89}"/>
          </ac:picMkLst>
        </pc:picChg>
        <pc:picChg chg="add mod">
          <ac:chgData name="yariv greenshpan" userId="04267bd6-eb40-4405-bb71-e4e8b5a7539f" providerId="ADAL" clId="{46E6BF90-D52F-4CFB-A15C-3DF35EC790DF}" dt="2022-03-14T11:26:26.709" v="283" actId="408"/>
          <ac:picMkLst>
            <pc:docMk/>
            <pc:sldMk cId="1243598662" sldId="281"/>
            <ac:picMk id="16" creationId="{1F9B28A8-8317-4C96-B2BE-F0B8BD580334}"/>
          </ac:picMkLst>
        </pc:picChg>
        <pc:picChg chg="add mod">
          <ac:chgData name="yariv greenshpan" userId="04267bd6-eb40-4405-bb71-e4e8b5a7539f" providerId="ADAL" clId="{46E6BF90-D52F-4CFB-A15C-3DF35EC790DF}" dt="2022-03-14T11:26:26.709" v="283" actId="408"/>
          <ac:picMkLst>
            <pc:docMk/>
            <pc:sldMk cId="1243598662" sldId="281"/>
            <ac:picMk id="17" creationId="{F6AE4D10-ED78-489E-9072-F52BD7B5E0E8}"/>
          </ac:picMkLst>
        </pc:picChg>
        <pc:picChg chg="add mod">
          <ac:chgData name="yariv greenshpan" userId="04267bd6-eb40-4405-bb71-e4e8b5a7539f" providerId="ADAL" clId="{46E6BF90-D52F-4CFB-A15C-3DF35EC790DF}" dt="2022-03-14T11:26:26.709" v="283" actId="408"/>
          <ac:picMkLst>
            <pc:docMk/>
            <pc:sldMk cId="1243598662" sldId="281"/>
            <ac:picMk id="18" creationId="{87588DAB-DD74-4F5B-BF71-10D0553E815F}"/>
          </ac:picMkLst>
        </pc:picChg>
        <pc:picChg chg="add mod">
          <ac:chgData name="yariv greenshpan" userId="04267bd6-eb40-4405-bb71-e4e8b5a7539f" providerId="ADAL" clId="{46E6BF90-D52F-4CFB-A15C-3DF35EC790DF}" dt="2022-03-14T11:26:26.709" v="283" actId="408"/>
          <ac:picMkLst>
            <pc:docMk/>
            <pc:sldMk cId="1243598662" sldId="281"/>
            <ac:picMk id="19" creationId="{B1501433-80F3-4D5E-B7D9-514D9DFDBE1B}"/>
          </ac:picMkLst>
        </pc:picChg>
        <pc:cxnChg chg="add mod">
          <ac:chgData name="yariv greenshpan" userId="04267bd6-eb40-4405-bb71-e4e8b5a7539f" providerId="ADAL" clId="{46E6BF90-D52F-4CFB-A15C-3DF35EC790DF}" dt="2022-03-14T11:26:15.242" v="282" actId="408"/>
          <ac:cxnSpMkLst>
            <pc:docMk/>
            <pc:sldMk cId="1243598662" sldId="281"/>
            <ac:cxnSpMk id="20" creationId="{12DE60F5-0945-4533-B5A7-D05152699D1C}"/>
          </ac:cxnSpMkLst>
        </pc:cxnChg>
        <pc:cxnChg chg="add mod">
          <ac:chgData name="yariv greenshpan" userId="04267bd6-eb40-4405-bb71-e4e8b5a7539f" providerId="ADAL" clId="{46E6BF90-D52F-4CFB-A15C-3DF35EC790DF}" dt="2022-03-14T11:25:02.858" v="250" actId="1036"/>
          <ac:cxnSpMkLst>
            <pc:docMk/>
            <pc:sldMk cId="1243598662" sldId="281"/>
            <ac:cxnSpMk id="21" creationId="{CC9C1B55-B835-4784-894D-BE8818FF9A0F}"/>
          </ac:cxnSpMkLst>
        </pc:cxnChg>
      </pc:sldChg>
      <pc:sldChg chg="addSp delSp modSp add">
        <pc:chgData name="yariv greenshpan" userId="04267bd6-eb40-4405-bb71-e4e8b5a7539f" providerId="ADAL" clId="{46E6BF90-D52F-4CFB-A15C-3DF35EC790DF}" dt="2022-03-15T11:36:14.179" v="486" actId="20577"/>
        <pc:sldMkLst>
          <pc:docMk/>
          <pc:sldMk cId="1646673487" sldId="282"/>
        </pc:sldMkLst>
        <pc:spChg chg="del mod">
          <ac:chgData name="yariv greenshpan" userId="04267bd6-eb40-4405-bb71-e4e8b5a7539f" providerId="ADAL" clId="{46E6BF90-D52F-4CFB-A15C-3DF35EC790DF}" dt="2022-03-15T11:33:55.286" v="425" actId="478"/>
          <ac:spMkLst>
            <pc:docMk/>
            <pc:sldMk cId="1646673487" sldId="282"/>
            <ac:spMk id="3" creationId="{8DA3DD7E-C779-4D57-91C2-6BD05DEF064C}"/>
          </ac:spMkLst>
        </pc:spChg>
        <pc:spChg chg="add mod">
          <ac:chgData name="yariv greenshpan" userId="04267bd6-eb40-4405-bb71-e4e8b5a7539f" providerId="ADAL" clId="{46E6BF90-D52F-4CFB-A15C-3DF35EC790DF}" dt="2022-03-15T11:34:27.400" v="443" actId="20577"/>
          <ac:spMkLst>
            <pc:docMk/>
            <pc:sldMk cId="1646673487" sldId="282"/>
            <ac:spMk id="5" creationId="{D10F0BCA-6634-463F-913A-D0D1700D3E91}"/>
          </ac:spMkLst>
        </pc:spChg>
        <pc:spChg chg="del">
          <ac:chgData name="yariv greenshpan" userId="04267bd6-eb40-4405-bb71-e4e8b5a7539f" providerId="ADAL" clId="{46E6BF90-D52F-4CFB-A15C-3DF35EC790DF}" dt="2022-03-15T11:30:16.193" v="348" actId="478"/>
          <ac:spMkLst>
            <pc:docMk/>
            <pc:sldMk cId="1646673487" sldId="282"/>
            <ac:spMk id="22" creationId="{B77AF016-A50E-48BD-AD5E-2D16360FEE36}"/>
          </ac:spMkLst>
        </pc:spChg>
        <pc:spChg chg="del">
          <ac:chgData name="yariv greenshpan" userId="04267bd6-eb40-4405-bb71-e4e8b5a7539f" providerId="ADAL" clId="{46E6BF90-D52F-4CFB-A15C-3DF35EC790DF}" dt="2022-03-15T11:30:16.193" v="348" actId="478"/>
          <ac:spMkLst>
            <pc:docMk/>
            <pc:sldMk cId="1646673487" sldId="282"/>
            <ac:spMk id="23" creationId="{D410667E-BFDC-41FF-BB02-073A0EB7F2C2}"/>
          </ac:spMkLst>
        </pc:spChg>
        <pc:spChg chg="add mod">
          <ac:chgData name="yariv greenshpan" userId="04267bd6-eb40-4405-bb71-e4e8b5a7539f" providerId="ADAL" clId="{46E6BF90-D52F-4CFB-A15C-3DF35EC790DF}" dt="2022-03-15T11:36:14.179" v="486" actId="20577"/>
          <ac:spMkLst>
            <pc:docMk/>
            <pc:sldMk cId="1646673487" sldId="282"/>
            <ac:spMk id="25" creationId="{5EFD2692-F30F-4235-94C7-F280ECFF7807}"/>
          </ac:spMkLst>
        </pc:spChg>
        <pc:spChg chg="del">
          <ac:chgData name="yariv greenshpan" userId="04267bd6-eb40-4405-bb71-e4e8b5a7539f" providerId="ADAL" clId="{46E6BF90-D52F-4CFB-A15C-3DF35EC790DF}" dt="2022-03-15T11:30:16.193" v="348" actId="478"/>
          <ac:spMkLst>
            <pc:docMk/>
            <pc:sldMk cId="1646673487" sldId="282"/>
            <ac:spMk id="26" creationId="{04C04DDC-8D5D-4B07-857D-18E6F0EC2844}"/>
          </ac:spMkLst>
        </pc:spChg>
        <pc:spChg chg="del">
          <ac:chgData name="yariv greenshpan" userId="04267bd6-eb40-4405-bb71-e4e8b5a7539f" providerId="ADAL" clId="{46E6BF90-D52F-4CFB-A15C-3DF35EC790DF}" dt="2022-03-15T11:30:16.193" v="348" actId="478"/>
          <ac:spMkLst>
            <pc:docMk/>
            <pc:sldMk cId="1646673487" sldId="282"/>
            <ac:spMk id="27" creationId="{1DF2D9E3-3D1A-4604-9446-AB6EE9106D8A}"/>
          </ac:spMkLst>
        </pc:spChg>
        <pc:spChg chg="del">
          <ac:chgData name="yariv greenshpan" userId="04267bd6-eb40-4405-bb71-e4e8b5a7539f" providerId="ADAL" clId="{46E6BF90-D52F-4CFB-A15C-3DF35EC790DF}" dt="2022-03-15T11:30:16.193" v="348" actId="478"/>
          <ac:spMkLst>
            <pc:docMk/>
            <pc:sldMk cId="1646673487" sldId="282"/>
            <ac:spMk id="28" creationId="{97D1AD37-B5B7-4116-B57E-83F4EFD321D0}"/>
          </ac:spMkLst>
        </pc:spChg>
        <pc:spChg chg="del">
          <ac:chgData name="yariv greenshpan" userId="04267bd6-eb40-4405-bb71-e4e8b5a7539f" providerId="ADAL" clId="{46E6BF90-D52F-4CFB-A15C-3DF35EC790DF}" dt="2022-03-15T11:30:16.193" v="348" actId="478"/>
          <ac:spMkLst>
            <pc:docMk/>
            <pc:sldMk cId="1646673487" sldId="282"/>
            <ac:spMk id="29" creationId="{2DE76CE7-0DDE-4C06-864A-868EB07B8205}"/>
          </ac:spMkLst>
        </pc:spChg>
        <pc:spChg chg="del">
          <ac:chgData name="yariv greenshpan" userId="04267bd6-eb40-4405-bb71-e4e8b5a7539f" providerId="ADAL" clId="{46E6BF90-D52F-4CFB-A15C-3DF35EC790DF}" dt="2022-03-15T11:30:16.193" v="348" actId="478"/>
          <ac:spMkLst>
            <pc:docMk/>
            <pc:sldMk cId="1646673487" sldId="282"/>
            <ac:spMk id="30" creationId="{EB35C23D-46BE-47CA-BCA1-A4B645140830}"/>
          </ac:spMkLst>
        </pc:spChg>
        <pc:spChg chg="del">
          <ac:chgData name="yariv greenshpan" userId="04267bd6-eb40-4405-bb71-e4e8b5a7539f" providerId="ADAL" clId="{46E6BF90-D52F-4CFB-A15C-3DF35EC790DF}" dt="2022-03-15T11:30:16.193" v="348" actId="478"/>
          <ac:spMkLst>
            <pc:docMk/>
            <pc:sldMk cId="1646673487" sldId="282"/>
            <ac:spMk id="31" creationId="{3CD9CA8D-C5BA-40ED-99DB-C1C7A86E63A7}"/>
          </ac:spMkLst>
        </pc:spChg>
        <pc:spChg chg="add mod">
          <ac:chgData name="yariv greenshpan" userId="04267bd6-eb40-4405-bb71-e4e8b5a7539f" providerId="ADAL" clId="{46E6BF90-D52F-4CFB-A15C-3DF35EC790DF}" dt="2022-03-15T11:36:03.061" v="459" actId="20577"/>
          <ac:spMkLst>
            <pc:docMk/>
            <pc:sldMk cId="1646673487" sldId="282"/>
            <ac:spMk id="32" creationId="{22E6EC33-7632-4D2D-B2EB-DF96F11CE1BF}"/>
          </ac:spMkLst>
        </pc:spChg>
        <pc:graphicFrameChg chg="add del mod">
          <ac:chgData name="yariv greenshpan" userId="04267bd6-eb40-4405-bb71-e4e8b5a7539f" providerId="ADAL" clId="{46E6BF90-D52F-4CFB-A15C-3DF35EC790DF}" dt="2022-03-15T11:30:51.082" v="351" actId="478"/>
          <ac:graphicFrameMkLst>
            <pc:docMk/>
            <pc:sldMk cId="1646673487" sldId="282"/>
            <ac:graphicFrameMk id="2" creationId="{2C885C56-C41B-4927-92FF-4E05A14C2FC7}"/>
          </ac:graphicFrameMkLst>
        </pc:graphicFrameChg>
        <pc:graphicFrameChg chg="add del mod">
          <ac:chgData name="yariv greenshpan" userId="04267bd6-eb40-4405-bb71-e4e8b5a7539f" providerId="ADAL" clId="{46E6BF90-D52F-4CFB-A15C-3DF35EC790DF}" dt="2022-03-15T11:35:42.610" v="451" actId="478"/>
          <ac:graphicFrameMkLst>
            <pc:docMk/>
            <pc:sldMk cId="1646673487" sldId="282"/>
            <ac:graphicFrameMk id="6" creationId="{1121092B-A278-4924-9F6D-009C36D29BBB}"/>
          </ac:graphicFrameMkLst>
        </pc:graphicFrameChg>
        <pc:graphicFrameChg chg="add">
          <ac:chgData name="yariv greenshpan" userId="04267bd6-eb40-4405-bb71-e4e8b5a7539f" providerId="ADAL" clId="{46E6BF90-D52F-4CFB-A15C-3DF35EC790DF}" dt="2022-03-15T11:33:40.259" v="420"/>
          <ac:graphicFrameMkLst>
            <pc:docMk/>
            <pc:sldMk cId="1646673487" sldId="282"/>
            <ac:graphicFrameMk id="24" creationId="{8F79FB2A-9C6F-4D5E-B182-0B82697095FF}"/>
          </ac:graphicFrameMkLst>
        </pc:graphicFrameChg>
        <pc:picChg chg="add mod modCrop">
          <ac:chgData name="yariv greenshpan" userId="04267bd6-eb40-4405-bb71-e4e8b5a7539f" providerId="ADAL" clId="{46E6BF90-D52F-4CFB-A15C-3DF35EC790DF}" dt="2022-03-15T11:34:16.931" v="432" actId="1076"/>
          <ac:picMkLst>
            <pc:docMk/>
            <pc:sldMk cId="1646673487" sldId="282"/>
            <ac:picMk id="4" creationId="{256C4184-B17D-40F5-ADD0-D2C8233CD87F}"/>
          </ac:picMkLst>
        </pc:picChg>
        <pc:picChg chg="add mod">
          <ac:chgData name="yariv greenshpan" userId="04267bd6-eb40-4405-bb71-e4e8b5a7539f" providerId="ADAL" clId="{46E6BF90-D52F-4CFB-A15C-3DF35EC790DF}" dt="2022-03-15T11:35:56.019" v="456" actId="14100"/>
          <ac:picMkLst>
            <pc:docMk/>
            <pc:sldMk cId="1646673487" sldId="282"/>
            <ac:picMk id="7" creationId="{79402E07-4B39-41F2-8851-FA2AE287F016}"/>
          </ac:picMkLst>
        </pc:picChg>
        <pc:picChg chg="del">
          <ac:chgData name="yariv greenshpan" userId="04267bd6-eb40-4405-bb71-e4e8b5a7539f" providerId="ADAL" clId="{46E6BF90-D52F-4CFB-A15C-3DF35EC790DF}" dt="2022-03-15T11:30:16.193" v="348" actId="478"/>
          <ac:picMkLst>
            <pc:docMk/>
            <pc:sldMk cId="1646673487" sldId="282"/>
            <ac:picMk id="12" creationId="{BA4EE91D-8123-4E84-98E2-C77A4BB86072}"/>
          </ac:picMkLst>
        </pc:picChg>
        <pc:picChg chg="del">
          <ac:chgData name="yariv greenshpan" userId="04267bd6-eb40-4405-bb71-e4e8b5a7539f" providerId="ADAL" clId="{46E6BF90-D52F-4CFB-A15C-3DF35EC790DF}" dt="2022-03-15T11:30:16.193" v="348" actId="478"/>
          <ac:picMkLst>
            <pc:docMk/>
            <pc:sldMk cId="1646673487" sldId="282"/>
            <ac:picMk id="13" creationId="{DD77A827-13E6-4B65-AC77-48BFEB4CBCD8}"/>
          </ac:picMkLst>
        </pc:picChg>
        <pc:picChg chg="del">
          <ac:chgData name="yariv greenshpan" userId="04267bd6-eb40-4405-bb71-e4e8b5a7539f" providerId="ADAL" clId="{46E6BF90-D52F-4CFB-A15C-3DF35EC790DF}" dt="2022-03-15T11:30:16.193" v="348" actId="478"/>
          <ac:picMkLst>
            <pc:docMk/>
            <pc:sldMk cId="1646673487" sldId="282"/>
            <ac:picMk id="14" creationId="{FFC3F275-4896-4B3F-8644-3174E1787050}"/>
          </ac:picMkLst>
        </pc:picChg>
        <pc:picChg chg="del">
          <ac:chgData name="yariv greenshpan" userId="04267bd6-eb40-4405-bb71-e4e8b5a7539f" providerId="ADAL" clId="{46E6BF90-D52F-4CFB-A15C-3DF35EC790DF}" dt="2022-03-15T11:30:16.193" v="348" actId="478"/>
          <ac:picMkLst>
            <pc:docMk/>
            <pc:sldMk cId="1646673487" sldId="282"/>
            <ac:picMk id="15" creationId="{7EB4B8E0-7227-4CAC-A65D-F3F3645D1C89}"/>
          </ac:picMkLst>
        </pc:picChg>
        <pc:picChg chg="del">
          <ac:chgData name="yariv greenshpan" userId="04267bd6-eb40-4405-bb71-e4e8b5a7539f" providerId="ADAL" clId="{46E6BF90-D52F-4CFB-A15C-3DF35EC790DF}" dt="2022-03-15T11:30:16.193" v="348" actId="478"/>
          <ac:picMkLst>
            <pc:docMk/>
            <pc:sldMk cId="1646673487" sldId="282"/>
            <ac:picMk id="16" creationId="{1F9B28A8-8317-4C96-B2BE-F0B8BD580334}"/>
          </ac:picMkLst>
        </pc:picChg>
        <pc:picChg chg="del">
          <ac:chgData name="yariv greenshpan" userId="04267bd6-eb40-4405-bb71-e4e8b5a7539f" providerId="ADAL" clId="{46E6BF90-D52F-4CFB-A15C-3DF35EC790DF}" dt="2022-03-15T11:30:16.193" v="348" actId="478"/>
          <ac:picMkLst>
            <pc:docMk/>
            <pc:sldMk cId="1646673487" sldId="282"/>
            <ac:picMk id="17" creationId="{F6AE4D10-ED78-489E-9072-F52BD7B5E0E8}"/>
          </ac:picMkLst>
        </pc:picChg>
        <pc:picChg chg="del">
          <ac:chgData name="yariv greenshpan" userId="04267bd6-eb40-4405-bb71-e4e8b5a7539f" providerId="ADAL" clId="{46E6BF90-D52F-4CFB-A15C-3DF35EC790DF}" dt="2022-03-15T11:30:16.193" v="348" actId="478"/>
          <ac:picMkLst>
            <pc:docMk/>
            <pc:sldMk cId="1646673487" sldId="282"/>
            <ac:picMk id="18" creationId="{87588DAB-DD74-4F5B-BF71-10D0553E815F}"/>
          </ac:picMkLst>
        </pc:picChg>
        <pc:picChg chg="del">
          <ac:chgData name="yariv greenshpan" userId="04267bd6-eb40-4405-bb71-e4e8b5a7539f" providerId="ADAL" clId="{46E6BF90-D52F-4CFB-A15C-3DF35EC790DF}" dt="2022-03-15T11:30:16.193" v="348" actId="478"/>
          <ac:picMkLst>
            <pc:docMk/>
            <pc:sldMk cId="1646673487" sldId="282"/>
            <ac:picMk id="19" creationId="{B1501433-80F3-4D5E-B7D9-514D9DFDBE1B}"/>
          </ac:picMkLst>
        </pc:picChg>
        <pc:cxnChg chg="del">
          <ac:chgData name="yariv greenshpan" userId="04267bd6-eb40-4405-bb71-e4e8b5a7539f" providerId="ADAL" clId="{46E6BF90-D52F-4CFB-A15C-3DF35EC790DF}" dt="2022-03-15T11:30:16.193" v="348" actId="478"/>
          <ac:cxnSpMkLst>
            <pc:docMk/>
            <pc:sldMk cId="1646673487" sldId="282"/>
            <ac:cxnSpMk id="20" creationId="{12DE60F5-0945-4533-B5A7-D05152699D1C}"/>
          </ac:cxnSpMkLst>
        </pc:cxnChg>
        <pc:cxnChg chg="del">
          <ac:chgData name="yariv greenshpan" userId="04267bd6-eb40-4405-bb71-e4e8b5a7539f" providerId="ADAL" clId="{46E6BF90-D52F-4CFB-A15C-3DF35EC790DF}" dt="2022-03-15T11:30:16.193" v="348" actId="478"/>
          <ac:cxnSpMkLst>
            <pc:docMk/>
            <pc:sldMk cId="1646673487" sldId="282"/>
            <ac:cxnSpMk id="21" creationId="{CC9C1B55-B835-4784-894D-BE8818FF9A0F}"/>
          </ac:cxnSpMkLst>
        </pc:cxnChg>
      </pc:sldChg>
    </pc:docChg>
  </pc:docChgLst>
  <pc:docChgLst>
    <pc:chgData name="yariv greenshpan" userId="04267bd6-eb40-4405-bb71-e4e8b5a7539f" providerId="ADAL" clId="{24DBBDB3-AAD0-4DA9-B4C3-4B47F36037C2}"/>
    <pc:docChg chg="custSel addSld modSld sldOrd">
      <pc:chgData name="yariv greenshpan" userId="04267bd6-eb40-4405-bb71-e4e8b5a7539f" providerId="ADAL" clId="{24DBBDB3-AAD0-4DA9-B4C3-4B47F36037C2}" dt="2022-03-08T12:41:12.434" v="163" actId="313"/>
      <pc:docMkLst>
        <pc:docMk/>
      </pc:docMkLst>
      <pc:sldChg chg="modSp">
        <pc:chgData name="yariv greenshpan" userId="04267bd6-eb40-4405-bb71-e4e8b5a7539f" providerId="ADAL" clId="{24DBBDB3-AAD0-4DA9-B4C3-4B47F36037C2}" dt="2022-03-08T12:38:19.980" v="7" actId="20577"/>
        <pc:sldMkLst>
          <pc:docMk/>
          <pc:sldMk cId="344118405" sldId="272"/>
        </pc:sldMkLst>
        <pc:spChg chg="mod">
          <ac:chgData name="yariv greenshpan" userId="04267bd6-eb40-4405-bb71-e4e8b5a7539f" providerId="ADAL" clId="{24DBBDB3-AAD0-4DA9-B4C3-4B47F36037C2}" dt="2022-03-08T12:38:19.980" v="7" actId="20577"/>
          <ac:spMkLst>
            <pc:docMk/>
            <pc:sldMk cId="344118405" sldId="272"/>
            <ac:spMk id="5" creationId="{00000000-0000-0000-0000-000000000000}"/>
          </ac:spMkLst>
        </pc:spChg>
      </pc:sldChg>
      <pc:sldChg chg="modSp">
        <pc:chgData name="yariv greenshpan" userId="04267bd6-eb40-4405-bb71-e4e8b5a7539f" providerId="ADAL" clId="{24DBBDB3-AAD0-4DA9-B4C3-4B47F36037C2}" dt="2022-03-08T12:38:15.101" v="5" actId="20577"/>
        <pc:sldMkLst>
          <pc:docMk/>
          <pc:sldMk cId="1411503484" sldId="273"/>
        </pc:sldMkLst>
        <pc:spChg chg="mod">
          <ac:chgData name="yariv greenshpan" userId="04267bd6-eb40-4405-bb71-e4e8b5a7539f" providerId="ADAL" clId="{24DBBDB3-AAD0-4DA9-B4C3-4B47F36037C2}" dt="2022-03-08T12:38:15.101" v="5" actId="20577"/>
          <ac:spMkLst>
            <pc:docMk/>
            <pc:sldMk cId="1411503484" sldId="273"/>
            <ac:spMk id="42" creationId="{00000000-0000-0000-0000-000000000000}"/>
          </ac:spMkLst>
        </pc:spChg>
      </pc:sldChg>
      <pc:sldChg chg="modSp">
        <pc:chgData name="yariv greenshpan" userId="04267bd6-eb40-4405-bb71-e4e8b5a7539f" providerId="ADAL" clId="{24DBBDB3-AAD0-4DA9-B4C3-4B47F36037C2}" dt="2022-03-08T12:38:24.012" v="9" actId="20577"/>
        <pc:sldMkLst>
          <pc:docMk/>
          <pc:sldMk cId="1837578986" sldId="278"/>
        </pc:sldMkLst>
        <pc:spChg chg="mod">
          <ac:chgData name="yariv greenshpan" userId="04267bd6-eb40-4405-bb71-e4e8b5a7539f" providerId="ADAL" clId="{24DBBDB3-AAD0-4DA9-B4C3-4B47F36037C2}" dt="2022-03-08T12:38:24.012" v="9" actId="20577"/>
          <ac:spMkLst>
            <pc:docMk/>
            <pc:sldMk cId="1837578986" sldId="278"/>
            <ac:spMk id="5" creationId="{00000000-0000-0000-0000-000000000000}"/>
          </ac:spMkLst>
        </pc:spChg>
      </pc:sldChg>
      <pc:sldChg chg="modSp">
        <pc:chgData name="yariv greenshpan" userId="04267bd6-eb40-4405-bb71-e4e8b5a7539f" providerId="ADAL" clId="{24DBBDB3-AAD0-4DA9-B4C3-4B47F36037C2}" dt="2022-03-08T12:38:28.366" v="11" actId="20577"/>
        <pc:sldMkLst>
          <pc:docMk/>
          <pc:sldMk cId="3803561595" sldId="279"/>
        </pc:sldMkLst>
        <pc:spChg chg="mod">
          <ac:chgData name="yariv greenshpan" userId="04267bd6-eb40-4405-bb71-e4e8b5a7539f" providerId="ADAL" clId="{24DBBDB3-AAD0-4DA9-B4C3-4B47F36037C2}" dt="2022-03-08T12:38:28.366" v="11" actId="20577"/>
          <ac:spMkLst>
            <pc:docMk/>
            <pc:sldMk cId="3803561595" sldId="279"/>
            <ac:spMk id="3" creationId="{8DA3DD7E-C779-4D57-91C2-6BD05DEF064C}"/>
          </ac:spMkLst>
        </pc:spChg>
      </pc:sldChg>
      <pc:sldChg chg="addSp modSp add ord">
        <pc:chgData name="yariv greenshpan" userId="04267bd6-eb40-4405-bb71-e4e8b5a7539f" providerId="ADAL" clId="{24DBBDB3-AAD0-4DA9-B4C3-4B47F36037C2}" dt="2022-03-08T12:41:12.434" v="163" actId="313"/>
        <pc:sldMkLst>
          <pc:docMk/>
          <pc:sldMk cId="2907499100" sldId="280"/>
        </pc:sldMkLst>
        <pc:spChg chg="add mod">
          <ac:chgData name="yariv greenshpan" userId="04267bd6-eb40-4405-bb71-e4e8b5a7539f" providerId="ADAL" clId="{24DBBDB3-AAD0-4DA9-B4C3-4B47F36037C2}" dt="2022-03-08T12:41:12.434" v="163" actId="313"/>
          <ac:spMkLst>
            <pc:docMk/>
            <pc:sldMk cId="2907499100" sldId="280"/>
            <ac:spMk id="3" creationId="{03C47D20-E738-41DB-A3F8-30F10B482F8D}"/>
          </ac:spMkLst>
        </pc:spChg>
        <pc:picChg chg="add mod">
          <ac:chgData name="yariv greenshpan" userId="04267bd6-eb40-4405-bb71-e4e8b5a7539f" providerId="ADAL" clId="{24DBBDB3-AAD0-4DA9-B4C3-4B47F36037C2}" dt="2022-03-08T12:37:57.282" v="2" actId="1076"/>
          <ac:picMkLst>
            <pc:docMk/>
            <pc:sldMk cId="2907499100" sldId="280"/>
            <ac:picMk id="2" creationId="{14BBB304-2D74-4EDD-9A73-7540347E2358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Omri\&#1499;&#1514;&#1497;&#1489;&#1492;\libraries%20manuscript\Figures\8+9.9.2020%20(os%20analysis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G:\Omri\&#1499;&#1514;&#1497;&#1489;&#1492;\libraries%20manuscript\Figures\8+9.9.2020%20(os%20analysis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medfs2.med.ad.bgu.ac.il\medgroups9\gazit-lab\Omri\FIGURES%20FOR%20LIB\8+9.9.202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H$172</c:f>
              <c:strCache>
                <c:ptCount val="1"/>
                <c:pt idx="0">
                  <c:v>cle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165:$AA$165</c:f>
                <c:numCache>
                  <c:formatCode>General</c:formatCode>
                  <c:ptCount val="19"/>
                  <c:pt idx="0">
                    <c:v>2.2776083947860768E-2</c:v>
                  </c:pt>
                  <c:pt idx="1">
                    <c:v>4.8476798574163198E-2</c:v>
                  </c:pt>
                  <c:pt idx="2">
                    <c:v>1.299038105676659E-2</c:v>
                  </c:pt>
                  <c:pt idx="3">
                    <c:v>1.4999999999999986E-2</c:v>
                  </c:pt>
                  <c:pt idx="4">
                    <c:v>2.4874685927665303E-2</c:v>
                  </c:pt>
                  <c:pt idx="5">
                    <c:v>6.1390145789043428E-2</c:v>
                  </c:pt>
                  <c:pt idx="6">
                    <c:v>1.8708286933869726E-2</c:v>
                  </c:pt>
                  <c:pt idx="7">
                    <c:v>1.2990381056766543E-2</c:v>
                  </c:pt>
                  <c:pt idx="8">
                    <c:v>1.0897247358851694E-2</c:v>
                  </c:pt>
                  <c:pt idx="9">
                    <c:v>2.1650635094610942E-2</c:v>
                  </c:pt>
                  <c:pt idx="10">
                    <c:v>0.14306903927824483</c:v>
                  </c:pt>
                  <c:pt idx="11">
                    <c:v>1.2990381056766576E-2</c:v>
                  </c:pt>
                  <c:pt idx="12">
                    <c:v>4.1833001326703811E-2</c:v>
                  </c:pt>
                  <c:pt idx="13">
                    <c:v>2.0615528128088301E-2</c:v>
                  </c:pt>
                  <c:pt idx="14">
                    <c:v>0.1493946116832868</c:v>
                  </c:pt>
                  <c:pt idx="15">
                    <c:v>0</c:v>
                  </c:pt>
                  <c:pt idx="16">
                    <c:v>2.5495097567963948E-2</c:v>
                  </c:pt>
                  <c:pt idx="17">
                    <c:v>0</c:v>
                  </c:pt>
                  <c:pt idx="18">
                    <c:v>3.1955985354859622</c:v>
                  </c:pt>
                </c:numCache>
              </c:numRef>
            </c:plus>
            <c:minus>
              <c:numRef>
                <c:f>Sheet1!$I$165:$AA$165</c:f>
                <c:numCache>
                  <c:formatCode>General</c:formatCode>
                  <c:ptCount val="19"/>
                  <c:pt idx="0">
                    <c:v>2.2776083947860768E-2</c:v>
                  </c:pt>
                  <c:pt idx="1">
                    <c:v>4.8476798574163198E-2</c:v>
                  </c:pt>
                  <c:pt idx="2">
                    <c:v>1.299038105676659E-2</c:v>
                  </c:pt>
                  <c:pt idx="3">
                    <c:v>1.4999999999999986E-2</c:v>
                  </c:pt>
                  <c:pt idx="4">
                    <c:v>2.4874685927665303E-2</c:v>
                  </c:pt>
                  <c:pt idx="5">
                    <c:v>6.1390145789043428E-2</c:v>
                  </c:pt>
                  <c:pt idx="6">
                    <c:v>1.8708286933869726E-2</c:v>
                  </c:pt>
                  <c:pt idx="7">
                    <c:v>1.2990381056766543E-2</c:v>
                  </c:pt>
                  <c:pt idx="8">
                    <c:v>1.0897247358851694E-2</c:v>
                  </c:pt>
                  <c:pt idx="9">
                    <c:v>2.1650635094610942E-2</c:v>
                  </c:pt>
                  <c:pt idx="10">
                    <c:v>0.14306903927824483</c:v>
                  </c:pt>
                  <c:pt idx="11">
                    <c:v>1.2990381056766576E-2</c:v>
                  </c:pt>
                  <c:pt idx="12">
                    <c:v>4.1833001326703811E-2</c:v>
                  </c:pt>
                  <c:pt idx="13">
                    <c:v>2.0615528128088301E-2</c:v>
                  </c:pt>
                  <c:pt idx="14">
                    <c:v>0.1493946116832868</c:v>
                  </c:pt>
                  <c:pt idx="15">
                    <c:v>0</c:v>
                  </c:pt>
                  <c:pt idx="16">
                    <c:v>2.5495097567963948E-2</c:v>
                  </c:pt>
                  <c:pt idx="17">
                    <c:v>0</c:v>
                  </c:pt>
                  <c:pt idx="18">
                    <c:v>3.19559853548596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171:$Z$171</c:f>
              <c:strCache>
                <c:ptCount val="18"/>
                <c:pt idx="0">
                  <c:v>seq_1</c:v>
                </c:pt>
                <c:pt idx="1">
                  <c:v>seq_3</c:v>
                </c:pt>
                <c:pt idx="2">
                  <c:v>seq_4</c:v>
                </c:pt>
                <c:pt idx="3">
                  <c:v>seq_5</c:v>
                </c:pt>
                <c:pt idx="4">
                  <c:v>seq_11</c:v>
                </c:pt>
                <c:pt idx="5">
                  <c:v>seq_21</c:v>
                </c:pt>
                <c:pt idx="6">
                  <c:v>seq_42</c:v>
                </c:pt>
                <c:pt idx="7">
                  <c:v>seq_45</c:v>
                </c:pt>
                <c:pt idx="8">
                  <c:v>seq_70</c:v>
                </c:pt>
                <c:pt idx="9">
                  <c:v>seq_71</c:v>
                </c:pt>
                <c:pt idx="10">
                  <c:v>seq_79</c:v>
                </c:pt>
                <c:pt idx="11">
                  <c:v>seq_90</c:v>
                </c:pt>
                <c:pt idx="12">
                  <c:v>seq_123</c:v>
                </c:pt>
                <c:pt idx="13">
                  <c:v>seq_130</c:v>
                </c:pt>
                <c:pt idx="14">
                  <c:v>seq_143</c:v>
                </c:pt>
                <c:pt idx="15">
                  <c:v>seq_146</c:v>
                </c:pt>
                <c:pt idx="16">
                  <c:v>seq_150</c:v>
                </c:pt>
                <c:pt idx="17">
                  <c:v>mini TK</c:v>
                </c:pt>
              </c:strCache>
            </c:strRef>
          </c:cat>
          <c:val>
            <c:numRef>
              <c:f>Sheet1!$I$158:$Z$158</c:f>
              <c:numCache>
                <c:formatCode>General</c:formatCode>
                <c:ptCount val="18"/>
                <c:pt idx="0">
                  <c:v>0.63249999999999995</c:v>
                </c:pt>
                <c:pt idx="1">
                  <c:v>2.56</c:v>
                </c:pt>
                <c:pt idx="2">
                  <c:v>0.85250000000000004</c:v>
                </c:pt>
                <c:pt idx="3">
                  <c:v>0.80500000000000005</c:v>
                </c:pt>
                <c:pt idx="4">
                  <c:v>4.8125</c:v>
                </c:pt>
                <c:pt idx="5">
                  <c:v>1.0024999999999999</c:v>
                </c:pt>
                <c:pt idx="6">
                  <c:v>0.84</c:v>
                </c:pt>
                <c:pt idx="7">
                  <c:v>0.70250000000000001</c:v>
                </c:pt>
                <c:pt idx="8">
                  <c:v>0.48749999999999999</c:v>
                </c:pt>
                <c:pt idx="9">
                  <c:v>0.71249999999999991</c:v>
                </c:pt>
                <c:pt idx="10">
                  <c:v>5.8925000000000001</c:v>
                </c:pt>
                <c:pt idx="11">
                  <c:v>0.22749999999999998</c:v>
                </c:pt>
                <c:pt idx="12">
                  <c:v>1.77</c:v>
                </c:pt>
                <c:pt idx="13">
                  <c:v>0.35500000000000004</c:v>
                </c:pt>
                <c:pt idx="14">
                  <c:v>3.9775</c:v>
                </c:pt>
                <c:pt idx="15">
                  <c:v>1.31</c:v>
                </c:pt>
                <c:pt idx="16">
                  <c:v>0.76</c:v>
                </c:pt>
                <c:pt idx="17">
                  <c:v>0.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60D-44F7-B944-64D1E94E391C}"/>
            </c:ext>
          </c:extLst>
        </c:ser>
        <c:ser>
          <c:idx val="1"/>
          <c:order val="1"/>
          <c:tx>
            <c:strRef>
              <c:f>Sheet1!$H$173</c:f>
              <c:strCache>
                <c:ptCount val="1"/>
                <c:pt idx="0">
                  <c:v>IFN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166:$AA$166</c:f>
                <c:numCache>
                  <c:formatCode>General</c:formatCode>
                  <c:ptCount val="19"/>
                  <c:pt idx="0">
                    <c:v>5.5452682532047083E-2</c:v>
                  </c:pt>
                  <c:pt idx="1">
                    <c:v>9.2330926563096938E-2</c:v>
                  </c:pt>
                  <c:pt idx="2">
                    <c:v>2.384848003542361E-2</c:v>
                  </c:pt>
                  <c:pt idx="3">
                    <c:v>8.2915619758885065E-3</c:v>
                  </c:pt>
                  <c:pt idx="4">
                    <c:v>3.3447720400649097E-2</c:v>
                  </c:pt>
                  <c:pt idx="5">
                    <c:v>4.3803538669838063E-2</c:v>
                  </c:pt>
                  <c:pt idx="6">
                    <c:v>1.8708286933869726E-2</c:v>
                  </c:pt>
                  <c:pt idx="7">
                    <c:v>1.0897247358851694E-2</c:v>
                  </c:pt>
                  <c:pt idx="8">
                    <c:v>1.1180339887498959E-2</c:v>
                  </c:pt>
                  <c:pt idx="9">
                    <c:v>8.6602540378443935E-3</c:v>
                  </c:pt>
                  <c:pt idx="10">
                    <c:v>8.916277250063484E-2</c:v>
                  </c:pt>
                  <c:pt idx="11">
                    <c:v>1.0897247358851682E-2</c:v>
                  </c:pt>
                  <c:pt idx="12">
                    <c:v>1.1180339887498959E-2</c:v>
                  </c:pt>
                  <c:pt idx="13">
                    <c:v>1.7853571071357141E-2</c:v>
                  </c:pt>
                  <c:pt idx="14">
                    <c:v>0.21324868112136125</c:v>
                  </c:pt>
                  <c:pt idx="15">
                    <c:v>0</c:v>
                  </c:pt>
                  <c:pt idx="16">
                    <c:v>1.2990381056766592E-2</c:v>
                  </c:pt>
                  <c:pt idx="17">
                    <c:v>3.5355339059327591E-2</c:v>
                  </c:pt>
                  <c:pt idx="18">
                    <c:v>8.0211201680313913</c:v>
                  </c:pt>
                </c:numCache>
              </c:numRef>
            </c:plus>
            <c:minus>
              <c:numRef>
                <c:f>Sheet1!$I$166:$AA$166</c:f>
                <c:numCache>
                  <c:formatCode>General</c:formatCode>
                  <c:ptCount val="19"/>
                  <c:pt idx="0">
                    <c:v>5.5452682532047083E-2</c:v>
                  </c:pt>
                  <c:pt idx="1">
                    <c:v>9.2330926563096938E-2</c:v>
                  </c:pt>
                  <c:pt idx="2">
                    <c:v>2.384848003542361E-2</c:v>
                  </c:pt>
                  <c:pt idx="3">
                    <c:v>8.2915619758885065E-3</c:v>
                  </c:pt>
                  <c:pt idx="4">
                    <c:v>3.3447720400649097E-2</c:v>
                  </c:pt>
                  <c:pt idx="5">
                    <c:v>4.3803538669838063E-2</c:v>
                  </c:pt>
                  <c:pt idx="6">
                    <c:v>1.8708286933869726E-2</c:v>
                  </c:pt>
                  <c:pt idx="7">
                    <c:v>1.0897247358851694E-2</c:v>
                  </c:pt>
                  <c:pt idx="8">
                    <c:v>1.1180339887498959E-2</c:v>
                  </c:pt>
                  <c:pt idx="9">
                    <c:v>8.6602540378443935E-3</c:v>
                  </c:pt>
                  <c:pt idx="10">
                    <c:v>8.916277250063484E-2</c:v>
                  </c:pt>
                  <c:pt idx="11">
                    <c:v>1.0897247358851682E-2</c:v>
                  </c:pt>
                  <c:pt idx="12">
                    <c:v>1.1180339887498959E-2</c:v>
                  </c:pt>
                  <c:pt idx="13">
                    <c:v>1.7853571071357141E-2</c:v>
                  </c:pt>
                  <c:pt idx="14">
                    <c:v>0.21324868112136125</c:v>
                  </c:pt>
                  <c:pt idx="15">
                    <c:v>0</c:v>
                  </c:pt>
                  <c:pt idx="16">
                    <c:v>1.2990381056766592E-2</c:v>
                  </c:pt>
                  <c:pt idx="17">
                    <c:v>3.5355339059327591E-2</c:v>
                  </c:pt>
                  <c:pt idx="18">
                    <c:v>8.02112016803139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171:$Z$171</c:f>
              <c:strCache>
                <c:ptCount val="18"/>
                <c:pt idx="0">
                  <c:v>seq_1</c:v>
                </c:pt>
                <c:pt idx="1">
                  <c:v>seq_3</c:v>
                </c:pt>
                <c:pt idx="2">
                  <c:v>seq_4</c:v>
                </c:pt>
                <c:pt idx="3">
                  <c:v>seq_5</c:v>
                </c:pt>
                <c:pt idx="4">
                  <c:v>seq_11</c:v>
                </c:pt>
                <c:pt idx="5">
                  <c:v>seq_21</c:v>
                </c:pt>
                <c:pt idx="6">
                  <c:v>seq_42</c:v>
                </c:pt>
                <c:pt idx="7">
                  <c:v>seq_45</c:v>
                </c:pt>
                <c:pt idx="8">
                  <c:v>seq_70</c:v>
                </c:pt>
                <c:pt idx="9">
                  <c:v>seq_71</c:v>
                </c:pt>
                <c:pt idx="10">
                  <c:v>seq_79</c:v>
                </c:pt>
                <c:pt idx="11">
                  <c:v>seq_90</c:v>
                </c:pt>
                <c:pt idx="12">
                  <c:v>seq_123</c:v>
                </c:pt>
                <c:pt idx="13">
                  <c:v>seq_130</c:v>
                </c:pt>
                <c:pt idx="14">
                  <c:v>seq_143</c:v>
                </c:pt>
                <c:pt idx="15">
                  <c:v>seq_146</c:v>
                </c:pt>
                <c:pt idx="16">
                  <c:v>seq_150</c:v>
                </c:pt>
                <c:pt idx="17">
                  <c:v>mini TK</c:v>
                </c:pt>
              </c:strCache>
            </c:strRef>
          </c:cat>
          <c:val>
            <c:numRef>
              <c:f>Sheet1!$I$159:$Z$159</c:f>
              <c:numCache>
                <c:formatCode>General</c:formatCode>
                <c:ptCount val="18"/>
                <c:pt idx="0">
                  <c:v>0.68500000000000005</c:v>
                </c:pt>
                <c:pt idx="1">
                  <c:v>2.2749999999999999</c:v>
                </c:pt>
                <c:pt idx="2">
                  <c:v>0.8125</c:v>
                </c:pt>
                <c:pt idx="3">
                  <c:v>0.89750000000000008</c:v>
                </c:pt>
                <c:pt idx="4">
                  <c:v>5.3225000000000007</c:v>
                </c:pt>
                <c:pt idx="5">
                  <c:v>0.91749999999999998</c:v>
                </c:pt>
                <c:pt idx="6">
                  <c:v>0.87</c:v>
                </c:pt>
                <c:pt idx="7">
                  <c:v>0.79749999999999999</c:v>
                </c:pt>
                <c:pt idx="8">
                  <c:v>0.505</c:v>
                </c:pt>
                <c:pt idx="9">
                  <c:v>0.75499999999999989</c:v>
                </c:pt>
                <c:pt idx="10">
                  <c:v>5.12</c:v>
                </c:pt>
                <c:pt idx="11">
                  <c:v>0.22249999999999998</c:v>
                </c:pt>
                <c:pt idx="12">
                  <c:v>1.575</c:v>
                </c:pt>
                <c:pt idx="13">
                  <c:v>0.49249999999999999</c:v>
                </c:pt>
                <c:pt idx="14">
                  <c:v>3.605</c:v>
                </c:pt>
                <c:pt idx="15">
                  <c:v>0.81</c:v>
                </c:pt>
                <c:pt idx="16">
                  <c:v>0.74250000000000005</c:v>
                </c:pt>
                <c:pt idx="17">
                  <c:v>0.350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60D-44F7-B944-64D1E94E391C}"/>
            </c:ext>
          </c:extLst>
        </c:ser>
        <c:ser>
          <c:idx val="2"/>
          <c:order val="2"/>
          <c:tx>
            <c:strRef>
              <c:f>Sheet1!$H$174</c:f>
              <c:strCache>
                <c:ptCount val="1"/>
                <c:pt idx="0">
                  <c:v>TNF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167:$AA$167</c:f>
                <c:numCache>
                  <c:formatCode>General</c:formatCode>
                  <c:ptCount val="19"/>
                  <c:pt idx="0">
                    <c:v>1.7853571071357141E-2</c:v>
                  </c:pt>
                  <c:pt idx="1">
                    <c:v>9.2025811596530019E-2</c:v>
                  </c:pt>
                  <c:pt idx="2">
                    <c:v>4.2646805273079985E-2</c:v>
                  </c:pt>
                  <c:pt idx="3">
                    <c:v>0.14543039572248989</c:v>
                  </c:pt>
                  <c:pt idx="4">
                    <c:v>0.23038012067016558</c:v>
                  </c:pt>
                  <c:pt idx="5">
                    <c:v>3.2015621187164271E-2</c:v>
                  </c:pt>
                  <c:pt idx="6">
                    <c:v>3.3541019662496875E-2</c:v>
                  </c:pt>
                  <c:pt idx="7">
                    <c:v>4.3229041164476414E-2</c:v>
                  </c:pt>
                  <c:pt idx="8">
                    <c:v>7.0710678118654814E-3</c:v>
                  </c:pt>
                  <c:pt idx="9">
                    <c:v>5.4486236794258361E-2</c:v>
                  </c:pt>
                  <c:pt idx="10">
                    <c:v>0.3174114049620777</c:v>
                  </c:pt>
                  <c:pt idx="11">
                    <c:v>8.2915619758884961E-3</c:v>
                  </c:pt>
                  <c:pt idx="12">
                    <c:v>3.2787192621510031E-2</c:v>
                  </c:pt>
                  <c:pt idx="13">
                    <c:v>7.3950997288745157E-2</c:v>
                  </c:pt>
                  <c:pt idx="14">
                    <c:v>0.72059003601215599</c:v>
                  </c:pt>
                  <c:pt idx="15">
                    <c:v>0.80499999999999994</c:v>
                  </c:pt>
                  <c:pt idx="16">
                    <c:v>3.344772040064916E-2</c:v>
                  </c:pt>
                  <c:pt idx="17">
                    <c:v>2.4874685927665497E-2</c:v>
                  </c:pt>
                  <c:pt idx="18">
                    <c:v>4.0326604121845024</c:v>
                  </c:pt>
                </c:numCache>
              </c:numRef>
            </c:plus>
            <c:minus>
              <c:numRef>
                <c:f>Sheet1!$I$167:$AA$167</c:f>
                <c:numCache>
                  <c:formatCode>General</c:formatCode>
                  <c:ptCount val="19"/>
                  <c:pt idx="0">
                    <c:v>1.7853571071357141E-2</c:v>
                  </c:pt>
                  <c:pt idx="1">
                    <c:v>9.2025811596530019E-2</c:v>
                  </c:pt>
                  <c:pt idx="2">
                    <c:v>4.2646805273079985E-2</c:v>
                  </c:pt>
                  <c:pt idx="3">
                    <c:v>0.14543039572248989</c:v>
                  </c:pt>
                  <c:pt idx="4">
                    <c:v>0.23038012067016558</c:v>
                  </c:pt>
                  <c:pt idx="5">
                    <c:v>3.2015621187164271E-2</c:v>
                  </c:pt>
                  <c:pt idx="6">
                    <c:v>3.3541019662496875E-2</c:v>
                  </c:pt>
                  <c:pt idx="7">
                    <c:v>4.3229041164476414E-2</c:v>
                  </c:pt>
                  <c:pt idx="8">
                    <c:v>7.0710678118654814E-3</c:v>
                  </c:pt>
                  <c:pt idx="9">
                    <c:v>5.4486236794258361E-2</c:v>
                  </c:pt>
                  <c:pt idx="10">
                    <c:v>0.3174114049620777</c:v>
                  </c:pt>
                  <c:pt idx="11">
                    <c:v>8.2915619758884961E-3</c:v>
                  </c:pt>
                  <c:pt idx="12">
                    <c:v>3.2787192621510031E-2</c:v>
                  </c:pt>
                  <c:pt idx="13">
                    <c:v>7.3950997288745157E-2</c:v>
                  </c:pt>
                  <c:pt idx="14">
                    <c:v>0.72059003601215599</c:v>
                  </c:pt>
                  <c:pt idx="15">
                    <c:v>0.80499999999999994</c:v>
                  </c:pt>
                  <c:pt idx="16">
                    <c:v>3.344772040064916E-2</c:v>
                  </c:pt>
                  <c:pt idx="17">
                    <c:v>2.4874685927665497E-2</c:v>
                  </c:pt>
                  <c:pt idx="18">
                    <c:v>4.03266041218450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171:$Z$171</c:f>
              <c:strCache>
                <c:ptCount val="18"/>
                <c:pt idx="0">
                  <c:v>seq_1</c:v>
                </c:pt>
                <c:pt idx="1">
                  <c:v>seq_3</c:v>
                </c:pt>
                <c:pt idx="2">
                  <c:v>seq_4</c:v>
                </c:pt>
                <c:pt idx="3">
                  <c:v>seq_5</c:v>
                </c:pt>
                <c:pt idx="4">
                  <c:v>seq_11</c:v>
                </c:pt>
                <c:pt idx="5">
                  <c:v>seq_21</c:v>
                </c:pt>
                <c:pt idx="6">
                  <c:v>seq_42</c:v>
                </c:pt>
                <c:pt idx="7">
                  <c:v>seq_45</c:v>
                </c:pt>
                <c:pt idx="8">
                  <c:v>seq_70</c:v>
                </c:pt>
                <c:pt idx="9">
                  <c:v>seq_71</c:v>
                </c:pt>
                <c:pt idx="10">
                  <c:v>seq_79</c:v>
                </c:pt>
                <c:pt idx="11">
                  <c:v>seq_90</c:v>
                </c:pt>
                <c:pt idx="12">
                  <c:v>seq_123</c:v>
                </c:pt>
                <c:pt idx="13">
                  <c:v>seq_130</c:v>
                </c:pt>
                <c:pt idx="14">
                  <c:v>seq_143</c:v>
                </c:pt>
                <c:pt idx="15">
                  <c:v>seq_146</c:v>
                </c:pt>
                <c:pt idx="16">
                  <c:v>seq_150</c:v>
                </c:pt>
                <c:pt idx="17">
                  <c:v>mini TK</c:v>
                </c:pt>
              </c:strCache>
            </c:strRef>
          </c:cat>
          <c:val>
            <c:numRef>
              <c:f>Sheet1!$I$160:$Z$160</c:f>
              <c:numCache>
                <c:formatCode>General</c:formatCode>
                <c:ptCount val="18"/>
                <c:pt idx="0">
                  <c:v>1.0874999999999999</c:v>
                </c:pt>
                <c:pt idx="1">
                  <c:v>4.5425000000000004</c:v>
                </c:pt>
                <c:pt idx="2">
                  <c:v>1.8125</c:v>
                </c:pt>
                <c:pt idx="3">
                  <c:v>3.32</c:v>
                </c:pt>
                <c:pt idx="4">
                  <c:v>4.8550000000000004</c:v>
                </c:pt>
                <c:pt idx="5">
                  <c:v>1.4749999999999999</c:v>
                </c:pt>
                <c:pt idx="6">
                  <c:v>1.5350000000000001</c:v>
                </c:pt>
                <c:pt idx="7">
                  <c:v>1.0825</c:v>
                </c:pt>
                <c:pt idx="8">
                  <c:v>0.64</c:v>
                </c:pt>
                <c:pt idx="9">
                  <c:v>1.6125</c:v>
                </c:pt>
                <c:pt idx="10">
                  <c:v>10.879999999999999</c:v>
                </c:pt>
                <c:pt idx="11">
                  <c:v>0.22749999999999998</c:v>
                </c:pt>
                <c:pt idx="12">
                  <c:v>2.3050000000000002</c:v>
                </c:pt>
                <c:pt idx="13">
                  <c:v>1.3625000000000003</c:v>
                </c:pt>
                <c:pt idx="14">
                  <c:v>8.4400000000000013</c:v>
                </c:pt>
                <c:pt idx="15">
                  <c:v>1.105</c:v>
                </c:pt>
                <c:pt idx="16">
                  <c:v>1.5375000000000001</c:v>
                </c:pt>
                <c:pt idx="17">
                  <c:v>0.3275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60D-44F7-B944-64D1E94E391C}"/>
            </c:ext>
          </c:extLst>
        </c:ser>
        <c:ser>
          <c:idx val="3"/>
          <c:order val="3"/>
          <c:tx>
            <c:strRef>
              <c:f>Sheet1!$H$175</c:f>
              <c:strCache>
                <c:ptCount val="1"/>
                <c:pt idx="0">
                  <c:v>IFN+TNF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168:$AA$168</c:f>
                <c:numCache>
                  <c:formatCode>General</c:formatCode>
                  <c:ptCount val="19"/>
                  <c:pt idx="0">
                    <c:v>6.495190528383285E-2</c:v>
                  </c:pt>
                  <c:pt idx="1">
                    <c:v>2.598076211353299E-2</c:v>
                  </c:pt>
                  <c:pt idx="2">
                    <c:v>0.12893796958227627</c:v>
                  </c:pt>
                  <c:pt idx="3">
                    <c:v>0.74702744260167675</c:v>
                  </c:pt>
                  <c:pt idx="4">
                    <c:v>0.27689122412962114</c:v>
                  </c:pt>
                  <c:pt idx="5">
                    <c:v>4.6569840025492935E-2</c:v>
                  </c:pt>
                  <c:pt idx="6">
                    <c:v>7.8859051477937481E-2</c:v>
                  </c:pt>
                  <c:pt idx="7">
                    <c:v>7.8222439235810029E-2</c:v>
                  </c:pt>
                  <c:pt idx="8">
                    <c:v>4.8153400710645541E-2</c:v>
                  </c:pt>
                  <c:pt idx="9">
                    <c:v>9.7082439194737968E-2</c:v>
                  </c:pt>
                  <c:pt idx="10">
                    <c:v>0.43280336181688789</c:v>
                  </c:pt>
                  <c:pt idx="11">
                    <c:v>4.3301270189221846E-3</c:v>
                  </c:pt>
                  <c:pt idx="12">
                    <c:v>4.7631397208144119E-2</c:v>
                  </c:pt>
                  <c:pt idx="13">
                    <c:v>0.4254042195371382</c:v>
                  </c:pt>
                  <c:pt idx="14">
                    <c:v>0.95643543953577947</c:v>
                  </c:pt>
                  <c:pt idx="15">
                    <c:v>0</c:v>
                  </c:pt>
                  <c:pt idx="16">
                    <c:v>0.23366642891095984</c:v>
                  </c:pt>
                  <c:pt idx="17">
                    <c:v>1.0897247358851694E-2</c:v>
                  </c:pt>
                  <c:pt idx="18">
                    <c:v>3.3125773575872932</c:v>
                  </c:pt>
                </c:numCache>
              </c:numRef>
            </c:plus>
            <c:minus>
              <c:numRef>
                <c:f>Sheet1!$I$168:$AA$168</c:f>
                <c:numCache>
                  <c:formatCode>General</c:formatCode>
                  <c:ptCount val="19"/>
                  <c:pt idx="0">
                    <c:v>6.495190528383285E-2</c:v>
                  </c:pt>
                  <c:pt idx="1">
                    <c:v>2.598076211353299E-2</c:v>
                  </c:pt>
                  <c:pt idx="2">
                    <c:v>0.12893796958227627</c:v>
                  </c:pt>
                  <c:pt idx="3">
                    <c:v>0.74702744260167675</c:v>
                  </c:pt>
                  <c:pt idx="4">
                    <c:v>0.27689122412962114</c:v>
                  </c:pt>
                  <c:pt idx="5">
                    <c:v>4.6569840025492935E-2</c:v>
                  </c:pt>
                  <c:pt idx="6">
                    <c:v>7.8859051477937481E-2</c:v>
                  </c:pt>
                  <c:pt idx="7">
                    <c:v>7.8222439235810029E-2</c:v>
                  </c:pt>
                  <c:pt idx="8">
                    <c:v>4.8153400710645541E-2</c:v>
                  </c:pt>
                  <c:pt idx="9">
                    <c:v>9.7082439194737968E-2</c:v>
                  </c:pt>
                  <c:pt idx="10">
                    <c:v>0.43280336181688789</c:v>
                  </c:pt>
                  <c:pt idx="11">
                    <c:v>4.3301270189221846E-3</c:v>
                  </c:pt>
                  <c:pt idx="12">
                    <c:v>4.7631397208144119E-2</c:v>
                  </c:pt>
                  <c:pt idx="13">
                    <c:v>0.4254042195371382</c:v>
                  </c:pt>
                  <c:pt idx="14">
                    <c:v>0.95643543953577947</c:v>
                  </c:pt>
                  <c:pt idx="15">
                    <c:v>0</c:v>
                  </c:pt>
                  <c:pt idx="16">
                    <c:v>0.23366642891095984</c:v>
                  </c:pt>
                  <c:pt idx="17">
                    <c:v>1.0897247358851694E-2</c:v>
                  </c:pt>
                  <c:pt idx="18">
                    <c:v>3.31257735758729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I$171:$Z$171</c:f>
              <c:strCache>
                <c:ptCount val="18"/>
                <c:pt idx="0">
                  <c:v>seq_1</c:v>
                </c:pt>
                <c:pt idx="1">
                  <c:v>seq_3</c:v>
                </c:pt>
                <c:pt idx="2">
                  <c:v>seq_4</c:v>
                </c:pt>
                <c:pt idx="3">
                  <c:v>seq_5</c:v>
                </c:pt>
                <c:pt idx="4">
                  <c:v>seq_11</c:v>
                </c:pt>
                <c:pt idx="5">
                  <c:v>seq_21</c:v>
                </c:pt>
                <c:pt idx="6">
                  <c:v>seq_42</c:v>
                </c:pt>
                <c:pt idx="7">
                  <c:v>seq_45</c:v>
                </c:pt>
                <c:pt idx="8">
                  <c:v>seq_70</c:v>
                </c:pt>
                <c:pt idx="9">
                  <c:v>seq_71</c:v>
                </c:pt>
                <c:pt idx="10">
                  <c:v>seq_79</c:v>
                </c:pt>
                <c:pt idx="11">
                  <c:v>seq_90</c:v>
                </c:pt>
                <c:pt idx="12">
                  <c:v>seq_123</c:v>
                </c:pt>
                <c:pt idx="13">
                  <c:v>seq_130</c:v>
                </c:pt>
                <c:pt idx="14">
                  <c:v>seq_143</c:v>
                </c:pt>
                <c:pt idx="15">
                  <c:v>seq_146</c:v>
                </c:pt>
                <c:pt idx="16">
                  <c:v>seq_150</c:v>
                </c:pt>
                <c:pt idx="17">
                  <c:v>mini TK</c:v>
                </c:pt>
              </c:strCache>
            </c:strRef>
          </c:cat>
          <c:val>
            <c:numRef>
              <c:f>Sheet1!$I$161:$Z$161</c:f>
              <c:numCache>
                <c:formatCode>General</c:formatCode>
                <c:ptCount val="18"/>
                <c:pt idx="0">
                  <c:v>1.3425</c:v>
                </c:pt>
                <c:pt idx="1">
                  <c:v>4.1550000000000002</c:v>
                </c:pt>
                <c:pt idx="2">
                  <c:v>2.145</c:v>
                </c:pt>
                <c:pt idx="3">
                  <c:v>6.1700000000000008</c:v>
                </c:pt>
                <c:pt idx="4">
                  <c:v>5.2475000000000005</c:v>
                </c:pt>
                <c:pt idx="5">
                  <c:v>1.8075000000000001</c:v>
                </c:pt>
                <c:pt idx="6">
                  <c:v>1.9224999999999999</c:v>
                </c:pt>
                <c:pt idx="7">
                  <c:v>1.8325</c:v>
                </c:pt>
                <c:pt idx="8">
                  <c:v>0.94750000000000001</c:v>
                </c:pt>
                <c:pt idx="9">
                  <c:v>2.1550000000000002</c:v>
                </c:pt>
                <c:pt idx="10">
                  <c:v>12.387500000000001</c:v>
                </c:pt>
                <c:pt idx="11">
                  <c:v>0.23249999999999998</c:v>
                </c:pt>
                <c:pt idx="12">
                  <c:v>2.2424999999999997</c:v>
                </c:pt>
                <c:pt idx="13">
                  <c:v>4.2324999999999999</c:v>
                </c:pt>
                <c:pt idx="14">
                  <c:v>10.282500000000001</c:v>
                </c:pt>
                <c:pt idx="15">
                  <c:v>0</c:v>
                </c:pt>
                <c:pt idx="16">
                  <c:v>2.3099999999999996</c:v>
                </c:pt>
                <c:pt idx="17">
                  <c:v>0.3774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60D-44F7-B944-64D1E94E39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5478928"/>
        <c:axId val="425484808"/>
      </c:barChart>
      <c:catAx>
        <c:axId val="425478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425484808"/>
        <c:crosses val="autoZero"/>
        <c:auto val="1"/>
        <c:lblAlgn val="ctr"/>
        <c:lblOffset val="100"/>
        <c:noMultiLvlLbl val="0"/>
      </c:catAx>
      <c:valAx>
        <c:axId val="4254848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w MFI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4254789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he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85000"/>
                <a:lumOff val="1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I$173:$Z$173</c:f>
              <c:strCache>
                <c:ptCount val="18"/>
                <c:pt idx="0">
                  <c:v>seq_1</c:v>
                </c:pt>
                <c:pt idx="1">
                  <c:v>seq_3</c:v>
                </c:pt>
                <c:pt idx="2">
                  <c:v>seq_4</c:v>
                </c:pt>
                <c:pt idx="3">
                  <c:v>seq_5</c:v>
                </c:pt>
                <c:pt idx="4">
                  <c:v>seq_11</c:v>
                </c:pt>
                <c:pt idx="5">
                  <c:v>seq_21</c:v>
                </c:pt>
                <c:pt idx="6">
                  <c:v>seq_42</c:v>
                </c:pt>
                <c:pt idx="7">
                  <c:v>seq_45</c:v>
                </c:pt>
                <c:pt idx="8">
                  <c:v>seq_70</c:v>
                </c:pt>
                <c:pt idx="9">
                  <c:v>seq_71</c:v>
                </c:pt>
                <c:pt idx="10">
                  <c:v>seq_79</c:v>
                </c:pt>
                <c:pt idx="11">
                  <c:v>seq_90</c:v>
                </c:pt>
                <c:pt idx="12">
                  <c:v>seq_123</c:v>
                </c:pt>
                <c:pt idx="13">
                  <c:v>seq_130</c:v>
                </c:pt>
                <c:pt idx="14">
                  <c:v>seq_143</c:v>
                </c:pt>
                <c:pt idx="15">
                  <c:v>seq_146</c:v>
                </c:pt>
                <c:pt idx="16">
                  <c:v>seq_150</c:v>
                </c:pt>
                <c:pt idx="17">
                  <c:v>mini TK</c:v>
                </c:pt>
              </c:strCache>
            </c:strRef>
          </c:cat>
          <c:val>
            <c:numRef>
              <c:f>Sheet1!$I$180:$Z$180</c:f>
              <c:numCache>
                <c:formatCode>General</c:formatCode>
                <c:ptCount val="18"/>
                <c:pt idx="0">
                  <c:v>2.9764705882352938</c:v>
                </c:pt>
                <c:pt idx="1">
                  <c:v>11.37777777777778</c:v>
                </c:pt>
                <c:pt idx="2">
                  <c:v>3.9195402298850577</c:v>
                </c:pt>
                <c:pt idx="3">
                  <c:v>3.9268292682926829</c:v>
                </c:pt>
                <c:pt idx="4">
                  <c:v>20.263157894736842</c:v>
                </c:pt>
                <c:pt idx="5">
                  <c:v>4.5568181818181825</c:v>
                </c:pt>
                <c:pt idx="6">
                  <c:v>3.8181818181818179</c:v>
                </c:pt>
                <c:pt idx="7">
                  <c:v>3.1573033707865168</c:v>
                </c:pt>
                <c:pt idx="8">
                  <c:v>2.3214285714285716</c:v>
                </c:pt>
                <c:pt idx="9">
                  <c:v>3.3928571428571423</c:v>
                </c:pt>
                <c:pt idx="10">
                  <c:v>22.447619047619046</c:v>
                </c:pt>
                <c:pt idx="11">
                  <c:v>1.0459770114942528</c:v>
                </c:pt>
                <c:pt idx="12">
                  <c:v>7.8666666666666663</c:v>
                </c:pt>
                <c:pt idx="13">
                  <c:v>1.6321839080459775</c:v>
                </c:pt>
                <c:pt idx="14">
                  <c:v>15.298076923076923</c:v>
                </c:pt>
                <c:pt idx="15">
                  <c:v>5.6956521739130439</c:v>
                </c:pt>
                <c:pt idx="16">
                  <c:v>3.2</c:v>
                </c:pt>
                <c:pt idx="17">
                  <c:v>1.54216867469879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CD-43DE-85FA-0C3FFFFF36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14347048"/>
        <c:axId val="385862144"/>
      </c:barChart>
      <c:catAx>
        <c:axId val="314347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85862144"/>
        <c:crosses val="autoZero"/>
        <c:auto val="1"/>
        <c:lblAlgn val="ctr"/>
        <c:lblOffset val="100"/>
        <c:noMultiLvlLbl val="0"/>
      </c:catAx>
      <c:valAx>
        <c:axId val="385862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background express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143470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</a:defRPr>
      </a:pPr>
      <a:endParaRPr lang="he-I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I$190:$Z$190</c:f>
              <c:strCache>
                <c:ptCount val="18"/>
                <c:pt idx="0">
                  <c:v>seq_1</c:v>
                </c:pt>
                <c:pt idx="1">
                  <c:v>seq_3</c:v>
                </c:pt>
                <c:pt idx="2">
                  <c:v>seq_4</c:v>
                </c:pt>
                <c:pt idx="3">
                  <c:v>seq_5</c:v>
                </c:pt>
                <c:pt idx="4">
                  <c:v>seq_11</c:v>
                </c:pt>
                <c:pt idx="5">
                  <c:v>seq_21</c:v>
                </c:pt>
                <c:pt idx="6">
                  <c:v>seq_42</c:v>
                </c:pt>
                <c:pt idx="7">
                  <c:v>seq_45</c:v>
                </c:pt>
                <c:pt idx="8">
                  <c:v>seq_70</c:v>
                </c:pt>
                <c:pt idx="9">
                  <c:v>seq_71</c:v>
                </c:pt>
                <c:pt idx="10">
                  <c:v>seq_79</c:v>
                </c:pt>
                <c:pt idx="11">
                  <c:v>seq_90</c:v>
                </c:pt>
                <c:pt idx="12">
                  <c:v>seq_123</c:v>
                </c:pt>
                <c:pt idx="13">
                  <c:v>seq_130</c:v>
                </c:pt>
                <c:pt idx="14">
                  <c:v>seq_143</c:v>
                </c:pt>
                <c:pt idx="15">
                  <c:v>seq_146</c:v>
                </c:pt>
                <c:pt idx="16">
                  <c:v>seq_150</c:v>
                </c:pt>
                <c:pt idx="17">
                  <c:v>mini TK</c:v>
                </c:pt>
              </c:strCache>
            </c:strRef>
          </c:cat>
          <c:val>
            <c:numRef>
              <c:f>Sheet1!$I$191:$Z$191</c:f>
              <c:numCache>
                <c:formatCode>General</c:formatCode>
                <c:ptCount val="18"/>
                <c:pt idx="0">
                  <c:v>1.2655034151307412</c:v>
                </c:pt>
                <c:pt idx="1">
                  <c:v>-0.72126593493945967</c:v>
                </c:pt>
                <c:pt idx="2">
                  <c:v>2.390828327501112</c:v>
                </c:pt>
                <c:pt idx="3">
                  <c:v>13.927804774411563</c:v>
                </c:pt>
                <c:pt idx="4">
                  <c:v>-8.7765106995448985</c:v>
                </c:pt>
                <c:pt idx="5">
                  <c:v>0.71224006241078519</c:v>
                </c:pt>
                <c:pt idx="6">
                  <c:v>1.8438987600800418</c:v>
                </c:pt>
                <c:pt idx="7">
                  <c:v>2.4434965096400822</c:v>
                </c:pt>
                <c:pt idx="8">
                  <c:v>0.98804710150355923</c:v>
                </c:pt>
                <c:pt idx="9">
                  <c:v>3.1851172039922329</c:v>
                </c:pt>
                <c:pt idx="10">
                  <c:v>5.1911979249780602</c:v>
                </c:pt>
                <c:pt idx="11">
                  <c:v>3.6175164233091528E-2</c:v>
                </c:pt>
                <c:pt idx="12">
                  <c:v>-2.0117592134085616</c:v>
                </c:pt>
                <c:pt idx="13">
                  <c:v>11.782748315336999</c:v>
                </c:pt>
                <c:pt idx="14">
                  <c:v>8.923409620768048</c:v>
                </c:pt>
                <c:pt idx="15">
                  <c:v>0</c:v>
                </c:pt>
                <c:pt idx="16">
                  <c:v>3.469712590340448</c:v>
                </c:pt>
                <c:pt idx="17">
                  <c:v>1.502689725692418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DC-4E53-950F-E18AE2C6E2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5859792"/>
        <c:axId val="385859008"/>
      </c:barChart>
      <c:catAx>
        <c:axId val="385859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85859008"/>
        <c:crosses val="autoZero"/>
        <c:auto val="1"/>
        <c:lblAlgn val="ctr"/>
        <c:lblOffset val="100"/>
        <c:noMultiLvlLbl val="0"/>
      </c:catAx>
      <c:valAx>
        <c:axId val="3858590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Potency scor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858597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19982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55915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92616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3812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97502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52847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80875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80274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24372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84185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54845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EBC59-C030-4BB9-AF91-D7F44709A568}" type="datetimeFigureOut">
              <a:rPr lang="he-IL" smtClean="0"/>
              <a:t>י"ח/אדר ב/תשפ"ב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09C599-7A1E-42D2-81EF-33396CF5FFA6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60461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18" Type="http://schemas.openxmlformats.org/officeDocument/2006/relationships/image" Target="../media/image1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17" Type="http://schemas.openxmlformats.org/officeDocument/2006/relationships/image" Target="../media/image17.emf"/><Relationship Id="rId2" Type="http://schemas.openxmlformats.org/officeDocument/2006/relationships/image" Target="../media/image2.emf"/><Relationship Id="rId16" Type="http://schemas.openxmlformats.org/officeDocument/2006/relationships/image" Target="../media/image16.emf"/><Relationship Id="rId20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19" Type="http://schemas.openxmlformats.org/officeDocument/2006/relationships/image" Target="../media/image19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Relationship Id="rId9" Type="http://schemas.openxmlformats.org/officeDocument/2006/relationships/image" Target="../media/image28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4BBB304-2D74-4EDD-9A73-7540347E23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611139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3C47D20-E738-41DB-A3F8-30F10B482F8D}"/>
              </a:ext>
            </a:extLst>
          </p:cNvPr>
          <p:cNvSpPr txBox="1"/>
          <p:nvPr/>
        </p:nvSpPr>
        <p:spPr>
          <a:xfrm>
            <a:off x="405245" y="6269696"/>
            <a:ext cx="58958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1 -</a:t>
            </a:r>
            <a:r>
              <a:rPr lang="en-US" sz="1200" dirty="0"/>
              <a:t> Representative schema of the </a:t>
            </a:r>
            <a:r>
              <a:rPr lang="en-US" sz="1200" dirty="0" err="1"/>
              <a:t>Lenti</a:t>
            </a:r>
            <a:r>
              <a:rPr lang="en-US" sz="1200" dirty="0"/>
              <a:t> vector used for screening the library promotor hits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2907499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243887" y="1207508"/>
            <a:ext cx="28055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4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71749" y="605676"/>
            <a:ext cx="108115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No cytokin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234294" y="605676"/>
            <a:ext cx="74814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IFN</a:t>
            </a:r>
            <a:r>
              <a:rPr lang="en-US" sz="1400" dirty="0">
                <a:sym typeface="Symbol" panose="05050102010706020507" pitchFamily="18" charset="2"/>
              </a:rPr>
              <a:t>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3730336" y="605676"/>
            <a:ext cx="74814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TNF</a:t>
            </a:r>
            <a:r>
              <a:rPr lang="el-GR" sz="1400" dirty="0">
                <a:sym typeface="Symbol" panose="05050102010706020507" pitchFamily="18" charset="2"/>
              </a:rPr>
              <a:t>α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4872361" y="605676"/>
            <a:ext cx="1288474" cy="43088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IFN</a:t>
            </a:r>
            <a:r>
              <a:rPr lang="en-US" sz="1400" dirty="0">
                <a:sym typeface="Symbol" panose="05050102010706020507" pitchFamily="18" charset="2"/>
              </a:rPr>
              <a:t> </a:t>
            </a:r>
            <a:r>
              <a:rPr lang="en-US" sz="1400" dirty="0"/>
              <a:t> +</a:t>
            </a:r>
            <a:r>
              <a:rPr lang="en-US" sz="1400" dirty="0" err="1"/>
              <a:t>TNFa</a:t>
            </a:r>
            <a:r>
              <a:rPr lang="el-GR" sz="1400" dirty="0">
                <a:sym typeface="Symbol" panose="05050102010706020507" pitchFamily="18" charset="2"/>
              </a:rPr>
              <a:t>α</a:t>
            </a:r>
            <a:endParaRPr lang="en-US" sz="1400" dirty="0"/>
          </a:p>
          <a:p>
            <a:pPr algn="ctr"/>
            <a:endParaRPr lang="en-US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6243887" y="2523266"/>
            <a:ext cx="28055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6243887" y="3975618"/>
            <a:ext cx="28055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11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151235" y="6723224"/>
            <a:ext cx="465859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130</a:t>
            </a:r>
          </a:p>
        </p:txBody>
      </p:sp>
      <p:cxnSp>
        <p:nvCxnSpPr>
          <p:cNvPr id="36" name="Straight Arrow Connector 35"/>
          <p:cNvCxnSpPr/>
          <p:nvPr/>
        </p:nvCxnSpPr>
        <p:spPr>
          <a:xfrm>
            <a:off x="405245" y="7710055"/>
            <a:ext cx="575867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 flipV="1">
            <a:off x="405245" y="993975"/>
            <a:ext cx="0" cy="671608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 rot="16200000">
            <a:off x="-480116" y="4007349"/>
            <a:ext cx="128847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/>
              <a:t>RFP</a:t>
            </a:r>
            <a:r>
              <a:rPr lang="he-IL" sz="1400" b="1" dirty="0"/>
              <a:t>670</a:t>
            </a:r>
            <a:endParaRPr lang="en-US" sz="14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2771549" y="7859848"/>
            <a:ext cx="74814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 err="1"/>
              <a:t>ZsGreen</a:t>
            </a:r>
            <a:endParaRPr lang="en-US" sz="14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405245" y="8197556"/>
            <a:ext cx="589586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2 -</a:t>
            </a:r>
            <a:r>
              <a:rPr lang="en-US" sz="1200" dirty="0"/>
              <a:t> Representative FACS plots of selected library sequences displaying promoter expression in response to cytokine combination. Data shown are single-discriminated, and DAPI-.</a:t>
            </a:r>
            <a:endParaRPr lang="en-US" sz="1000" dirty="0"/>
          </a:p>
        </p:txBody>
      </p:sp>
      <p:grpSp>
        <p:nvGrpSpPr>
          <p:cNvPr id="50" name="Group 49"/>
          <p:cNvGrpSpPr/>
          <p:nvPr/>
        </p:nvGrpSpPr>
        <p:grpSpPr>
          <a:xfrm>
            <a:off x="586850" y="967264"/>
            <a:ext cx="5442579" cy="6412727"/>
            <a:chOff x="586850" y="967264"/>
            <a:chExt cx="5442579" cy="6412727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86850" y="967264"/>
              <a:ext cx="1050950" cy="1036463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52443" y="967264"/>
              <a:ext cx="1048946" cy="1034487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15425" y="967264"/>
              <a:ext cx="1050586" cy="1036104"/>
            </a:xfrm>
            <a:prstGeom prst="rect">
              <a:avLst/>
            </a:prstGeom>
          </p:spPr>
        </p:pic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78409" y="967264"/>
              <a:ext cx="1048946" cy="1034487"/>
            </a:xfrm>
            <a:prstGeom prst="rect">
              <a:avLst/>
            </a:prstGeom>
          </p:spPr>
        </p:pic>
        <p:pic>
          <p:nvPicPr>
            <p:cNvPr id="20" name="Picture 1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86850" y="2282000"/>
              <a:ext cx="1051021" cy="1036533"/>
            </a:xfrm>
            <a:prstGeom prst="rect">
              <a:avLst/>
            </a:prstGeom>
          </p:spPr>
        </p:pic>
        <p:pic>
          <p:nvPicPr>
            <p:cNvPr id="21" name="Picture 2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052442" y="2282000"/>
              <a:ext cx="1051021" cy="1036533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515426" y="2282000"/>
              <a:ext cx="1051021" cy="1036533"/>
            </a:xfrm>
            <a:prstGeom prst="rect">
              <a:avLst/>
            </a:prstGeom>
          </p:spPr>
        </p:pic>
        <p:pic>
          <p:nvPicPr>
            <p:cNvPr id="23" name="Picture 2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978408" y="2281999"/>
              <a:ext cx="1051021" cy="1036533"/>
            </a:xfrm>
            <a:prstGeom prst="rect">
              <a:avLst/>
            </a:prstGeom>
          </p:spPr>
        </p:pic>
        <p:pic>
          <p:nvPicPr>
            <p:cNvPr id="25" name="Picture 24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86850" y="3596805"/>
              <a:ext cx="1051021" cy="1036533"/>
            </a:xfrm>
            <a:prstGeom prst="rect">
              <a:avLst/>
            </a:prstGeom>
          </p:spPr>
        </p:pic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052442" y="3596805"/>
              <a:ext cx="1051021" cy="1036533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515425" y="3596805"/>
              <a:ext cx="1051021" cy="1036533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978408" y="3596805"/>
              <a:ext cx="1051021" cy="1036533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01880" y="6343458"/>
              <a:ext cx="1051021" cy="1036533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064770" y="6343458"/>
              <a:ext cx="1051021" cy="1036533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515425" y="6325517"/>
              <a:ext cx="1051021" cy="1036533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4978408" y="6325517"/>
              <a:ext cx="1051021" cy="1036533"/>
            </a:xfrm>
            <a:prstGeom prst="rect">
              <a:avLst/>
            </a:prstGeom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90128" y="4915827"/>
              <a:ext cx="1051291" cy="1036800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2037986" y="4911691"/>
              <a:ext cx="1051292" cy="1036800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503943" y="4915827"/>
              <a:ext cx="1051292" cy="1036800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969900" y="4914803"/>
              <a:ext cx="1051292" cy="1036800"/>
            </a:xfrm>
            <a:prstGeom prst="rect">
              <a:avLst/>
            </a:prstGeom>
          </p:spPr>
        </p:pic>
      </p:grpSp>
      <p:sp>
        <p:nvSpPr>
          <p:cNvPr id="47" name="TextBox 46"/>
          <p:cNvSpPr txBox="1"/>
          <p:nvPr/>
        </p:nvSpPr>
        <p:spPr>
          <a:xfrm>
            <a:off x="6243887" y="5270872"/>
            <a:ext cx="28055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90</a:t>
            </a:r>
          </a:p>
        </p:txBody>
      </p:sp>
    </p:spTree>
    <p:extLst>
      <p:ext uri="{BB962C8B-B14F-4D97-AF65-F5344CB8AC3E}">
        <p14:creationId xmlns:p14="http://schemas.microsoft.com/office/powerpoint/2010/main" val="1411503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36478" y="4274218"/>
            <a:ext cx="49356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3 -</a:t>
            </a:r>
            <a:r>
              <a:rPr lang="en-US" sz="1200" dirty="0"/>
              <a:t> G1K06-library-derived sequence, raw </a:t>
            </a:r>
            <a:r>
              <a:rPr lang="en-US" sz="1200" dirty="0" err="1"/>
              <a:t>GeoMFI</a:t>
            </a:r>
            <a:r>
              <a:rPr lang="en-US" sz="1200" dirty="0"/>
              <a:t> normalized to uninfected cells.</a:t>
            </a:r>
          </a:p>
        </p:txBody>
      </p:sp>
      <p:graphicFrame>
        <p:nvGraphicFramePr>
          <p:cNvPr id="6" name="Chart 5"/>
          <p:cNvGraphicFramePr>
            <a:graphicFrameLocks noChangeAspect="1"/>
          </p:cNvGraphicFramePr>
          <p:nvPr>
            <p:extLst/>
          </p:nvPr>
        </p:nvGraphicFramePr>
        <p:xfrm>
          <a:off x="1" y="1405461"/>
          <a:ext cx="6858000" cy="28687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441184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0" y="656503"/>
          <a:ext cx="6858000" cy="2903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36478" y="3774687"/>
            <a:ext cx="62310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4 -</a:t>
            </a:r>
            <a:r>
              <a:rPr lang="en-US" sz="1200" dirty="0"/>
              <a:t> Background levels. Clone background MFI levels were divided by </a:t>
            </a:r>
            <a:r>
              <a:rPr lang="en-US" sz="1200" dirty="0" err="1"/>
              <a:t>miniTK</a:t>
            </a:r>
            <a:r>
              <a:rPr lang="en-US" sz="1200" dirty="0"/>
              <a:t> MFI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8375789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CDD61DC0-5C45-4B05-9A19-D6CD62F85E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5188260"/>
              </p:ext>
            </p:extLst>
          </p:nvPr>
        </p:nvGraphicFramePr>
        <p:xfrm>
          <a:off x="-28471" y="147376"/>
          <a:ext cx="6807096" cy="25422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DA3DD7E-C779-4D57-91C2-6BD05DEF064C}"/>
              </a:ext>
            </a:extLst>
          </p:cNvPr>
          <p:cNvSpPr txBox="1"/>
          <p:nvPr/>
        </p:nvSpPr>
        <p:spPr>
          <a:xfrm>
            <a:off x="436478" y="3042885"/>
            <a:ext cx="5434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5 -</a:t>
            </a:r>
            <a:r>
              <a:rPr lang="en-US" sz="1200" dirty="0"/>
              <a:t> Potency score calculated for raw </a:t>
            </a:r>
            <a:r>
              <a:rPr lang="en-US" sz="1200" dirty="0" err="1"/>
              <a:t>GeoMFI</a:t>
            </a:r>
            <a:r>
              <a:rPr lang="en-US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8035615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DA3DD7E-C779-4D57-91C2-6BD05DEF064C}"/>
              </a:ext>
            </a:extLst>
          </p:cNvPr>
          <p:cNvSpPr txBox="1"/>
          <p:nvPr/>
        </p:nvSpPr>
        <p:spPr>
          <a:xfrm>
            <a:off x="444457" y="4040509"/>
            <a:ext cx="5434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6 -</a:t>
            </a:r>
            <a:r>
              <a:rPr lang="en-US" sz="1200" dirty="0"/>
              <a:t> representative FACS plot for T cell promotor activity test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BA4EE91D-8123-4E84-98E2-C77A4BB860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993" y="463151"/>
            <a:ext cx="1273353" cy="126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D77A827-13E6-4B65-AC77-48BFEB4CBC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45542" y="463151"/>
            <a:ext cx="1273353" cy="1260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FC3F275-4896-4B3F-8644-3174E17870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90091" y="463151"/>
            <a:ext cx="1273353" cy="12600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EB4B8E0-7227-4CAC-A65D-F3F3645D1C8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34639" y="463151"/>
            <a:ext cx="1273353" cy="1260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F9B28A8-8317-4C96-B2BE-F0B8BD58033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0993" y="1941284"/>
            <a:ext cx="1273353" cy="1260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F6AE4D10-ED78-489E-9072-F52BD7B5E0E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45542" y="1941284"/>
            <a:ext cx="1273353" cy="1260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87588DAB-DD74-4F5B-BF71-10D0553E815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490091" y="1941284"/>
            <a:ext cx="1273353" cy="1260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B1501433-80F3-4D5E-B7D9-514D9DFDBE1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34639" y="1941284"/>
            <a:ext cx="1273353" cy="1260000"/>
          </a:xfrm>
          <a:prstGeom prst="rect">
            <a:avLst/>
          </a:prstGeom>
        </p:spPr>
      </p:pic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12DE60F5-0945-4533-B5A7-D05152699D1C}"/>
              </a:ext>
            </a:extLst>
          </p:cNvPr>
          <p:cNvCxnSpPr>
            <a:cxnSpLocks/>
          </p:cNvCxnSpPr>
          <p:nvPr/>
        </p:nvCxnSpPr>
        <p:spPr>
          <a:xfrm>
            <a:off x="405245" y="3424151"/>
            <a:ext cx="6201228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C9C1B55-B835-4784-894D-BE8818FF9A0F}"/>
              </a:ext>
            </a:extLst>
          </p:cNvPr>
          <p:cNvCxnSpPr>
            <a:cxnSpLocks/>
          </p:cNvCxnSpPr>
          <p:nvPr/>
        </p:nvCxnSpPr>
        <p:spPr>
          <a:xfrm flipV="1">
            <a:off x="405245" y="528843"/>
            <a:ext cx="0" cy="289530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B77AF016-A50E-48BD-AD5E-2D16360FEE36}"/>
              </a:ext>
            </a:extLst>
          </p:cNvPr>
          <p:cNvSpPr txBox="1"/>
          <p:nvPr/>
        </p:nvSpPr>
        <p:spPr>
          <a:xfrm rot="16200000">
            <a:off x="-480116" y="1719666"/>
            <a:ext cx="1288474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/>
              <a:t>RFP</a:t>
            </a:r>
            <a:r>
              <a:rPr lang="he-IL" sz="1400" b="1" dirty="0"/>
              <a:t>670</a:t>
            </a:r>
            <a:endParaRPr lang="en-US" sz="14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410667E-BFDC-41FF-BB02-073A0EB7F2C2}"/>
              </a:ext>
            </a:extLst>
          </p:cNvPr>
          <p:cNvSpPr txBox="1"/>
          <p:nvPr/>
        </p:nvSpPr>
        <p:spPr>
          <a:xfrm>
            <a:off x="2771549" y="3441124"/>
            <a:ext cx="74814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b="1" dirty="0" err="1"/>
              <a:t>ZsGreen</a:t>
            </a:r>
            <a:endParaRPr lang="en-US" sz="14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4C04DDC-8D5D-4B07-857D-18E6F0EC2844}"/>
              </a:ext>
            </a:extLst>
          </p:cNvPr>
          <p:cNvSpPr txBox="1"/>
          <p:nvPr/>
        </p:nvSpPr>
        <p:spPr>
          <a:xfrm>
            <a:off x="6243887" y="2523266"/>
            <a:ext cx="28055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DF2D9E3-3D1A-4604-9446-AB6EE9106D8A}"/>
              </a:ext>
            </a:extLst>
          </p:cNvPr>
          <p:cNvSpPr txBox="1"/>
          <p:nvPr/>
        </p:nvSpPr>
        <p:spPr>
          <a:xfrm>
            <a:off x="6207992" y="1075429"/>
            <a:ext cx="465859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13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7D1AD37-B5B7-4116-B57E-83F4EFD321D0}"/>
              </a:ext>
            </a:extLst>
          </p:cNvPr>
          <p:cNvSpPr txBox="1"/>
          <p:nvPr/>
        </p:nvSpPr>
        <p:spPr>
          <a:xfrm>
            <a:off x="647949" y="148476"/>
            <a:ext cx="1081152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No cytokine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DE76CE7-0DDE-4C06-864A-868EB07B8205}"/>
              </a:ext>
            </a:extLst>
          </p:cNvPr>
          <p:cNvSpPr txBox="1"/>
          <p:nvPr/>
        </p:nvSpPr>
        <p:spPr>
          <a:xfrm>
            <a:off x="2310494" y="148476"/>
            <a:ext cx="74814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IFN</a:t>
            </a:r>
            <a:r>
              <a:rPr lang="en-US" sz="1400" dirty="0">
                <a:sym typeface="Symbol" panose="05050102010706020507" pitchFamily="18" charset="2"/>
              </a:rPr>
              <a:t></a:t>
            </a:r>
            <a:endParaRPr lang="en-US"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B35C23D-46BE-47CA-BCA1-A4B645140830}"/>
              </a:ext>
            </a:extLst>
          </p:cNvPr>
          <p:cNvSpPr txBox="1"/>
          <p:nvPr/>
        </p:nvSpPr>
        <p:spPr>
          <a:xfrm>
            <a:off x="3806536" y="148476"/>
            <a:ext cx="748145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TNF</a:t>
            </a:r>
            <a:r>
              <a:rPr lang="el-GR" sz="1400" dirty="0">
                <a:sym typeface="Symbol" panose="05050102010706020507" pitchFamily="18" charset="2"/>
              </a:rPr>
              <a:t>α</a:t>
            </a:r>
            <a:endParaRPr lang="en-US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CD9CA8D-C5BA-40ED-99DB-C1C7A86E63A7}"/>
              </a:ext>
            </a:extLst>
          </p:cNvPr>
          <p:cNvSpPr txBox="1"/>
          <p:nvPr/>
        </p:nvSpPr>
        <p:spPr>
          <a:xfrm>
            <a:off x="4948561" y="148476"/>
            <a:ext cx="1288474" cy="430887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400" dirty="0"/>
              <a:t>IFN</a:t>
            </a:r>
            <a:r>
              <a:rPr lang="en-US" sz="1400" dirty="0">
                <a:sym typeface="Symbol" panose="05050102010706020507" pitchFamily="18" charset="2"/>
              </a:rPr>
              <a:t> </a:t>
            </a:r>
            <a:r>
              <a:rPr lang="en-US" sz="1400" dirty="0"/>
              <a:t> +</a:t>
            </a:r>
            <a:r>
              <a:rPr lang="en-US" sz="1400" dirty="0" err="1"/>
              <a:t>TNFa</a:t>
            </a:r>
            <a:r>
              <a:rPr lang="el-GR" sz="1400" dirty="0">
                <a:sym typeface="Symbol" panose="05050102010706020507" pitchFamily="18" charset="2"/>
              </a:rPr>
              <a:t>α</a:t>
            </a:r>
            <a:endParaRPr lang="en-US" sz="1400" dirty="0"/>
          </a:p>
          <a:p>
            <a:pPr algn="ctr"/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24359866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56C4184-B17D-40F5-ADD0-D2C8233CD87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78" t="1356" r="1853" b="2467"/>
          <a:stretch/>
        </p:blipFill>
        <p:spPr>
          <a:xfrm>
            <a:off x="600075" y="3581399"/>
            <a:ext cx="2900363" cy="1728789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EFD2692-F30F-4235-94C7-F280ECFF7807}"/>
              </a:ext>
            </a:extLst>
          </p:cNvPr>
          <p:cNvSpPr txBox="1"/>
          <p:nvPr/>
        </p:nvSpPr>
        <p:spPr>
          <a:xfrm>
            <a:off x="539707" y="5545459"/>
            <a:ext cx="54343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7 -</a:t>
            </a:r>
            <a:r>
              <a:rPr lang="en-US" sz="1200" dirty="0"/>
              <a:t> a. representative FACS plot for HeLa promotor activity test. b. normalized reporter expression of the </a:t>
            </a:r>
            <a:r>
              <a:rPr lang="en-US" sz="1200"/>
              <a:t>indicated promotors</a:t>
            </a:r>
            <a:endParaRPr lang="en-US" sz="1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10F0BCA-6634-463F-913A-D0D1700D3E91}"/>
              </a:ext>
            </a:extLst>
          </p:cNvPr>
          <p:cNvSpPr txBox="1"/>
          <p:nvPr/>
        </p:nvSpPr>
        <p:spPr>
          <a:xfrm>
            <a:off x="285750" y="3348038"/>
            <a:ext cx="284052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dirty="0"/>
              <a:t>b.</a:t>
            </a:r>
            <a:endParaRPr lang="he-IL" sz="10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79402E07-4B39-41F2-8851-FA2AE287F0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075" y="725401"/>
            <a:ext cx="3676650" cy="2681087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22E6EC33-7632-4D2D-B2EB-DF96F11CE1BF}"/>
              </a:ext>
            </a:extLst>
          </p:cNvPr>
          <p:cNvSpPr txBox="1"/>
          <p:nvPr/>
        </p:nvSpPr>
        <p:spPr>
          <a:xfrm>
            <a:off x="285750" y="479180"/>
            <a:ext cx="277640" cy="246221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000" dirty="0"/>
              <a:t>a.</a:t>
            </a:r>
            <a:endParaRPr lang="he-IL" sz="1000" dirty="0"/>
          </a:p>
        </p:txBody>
      </p:sp>
    </p:spTree>
    <p:extLst>
      <p:ext uri="{BB962C8B-B14F-4D97-AF65-F5344CB8AC3E}">
        <p14:creationId xmlns:p14="http://schemas.microsoft.com/office/powerpoint/2010/main" val="1646673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מסמך" ma:contentTypeID="0x010100A064A23859AC2742B92C1BBF73AACB70" ma:contentTypeVersion="11" ma:contentTypeDescription="צור מסמך חדש." ma:contentTypeScope="" ma:versionID="4ca49d16cc27f6f5e54c016e0981f60e">
  <xsd:schema xmlns:xsd="http://www.w3.org/2001/XMLSchema" xmlns:xs="http://www.w3.org/2001/XMLSchema" xmlns:p="http://schemas.microsoft.com/office/2006/metadata/properties" xmlns:ns3="1e6b9c30-ef70-4a65-b630-4eb845941252" targetNamespace="http://schemas.microsoft.com/office/2006/metadata/properties" ma:root="true" ma:fieldsID="d4666de0a0ebea26ac301665561486de" ns3:_="">
    <xsd:import namespace="1e6b9c30-ef70-4a65-b630-4eb84594125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6b9c30-ef70-4a65-b630-4eb84594125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סוג תוכן"/>
        <xsd:element ref="dc:title" minOccurs="0" maxOccurs="1" ma:index="4" ma:displayName="כותרת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5E924AFB-A189-4825-8107-5803D40EC47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6b9c30-ef70-4a65-b630-4eb84594125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EEC0D9F-E71F-4E52-9112-4BFB27F5F10B}">
  <ds:schemaRefs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openxmlformats.org/package/2006/metadata/core-properties"/>
    <ds:schemaRef ds:uri="http://www.w3.org/XML/1998/namespace"/>
    <ds:schemaRef ds:uri="http://schemas.microsoft.com/office/infopath/2007/PartnerControls"/>
    <ds:schemaRef ds:uri="1e6b9c30-ef70-4a65-b630-4eb845941252"/>
    <ds:schemaRef ds:uri="http://purl.org/dc/terms/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EFD245A5-6424-4DDD-9AFD-3E62C4BDBE67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</TotalTime>
  <Words>169</Words>
  <Application>Microsoft Office PowerPoint</Application>
  <PresentationFormat>A4 Paper (210x297 mm)</PresentationFormat>
  <Paragraphs>3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יריב גרינשפן</dc:creator>
  <cp:lastModifiedBy>יריב גרינשפן</cp:lastModifiedBy>
  <cp:revision>5</cp:revision>
  <dcterms:created xsi:type="dcterms:W3CDTF">2021-09-02T08:42:48Z</dcterms:created>
  <dcterms:modified xsi:type="dcterms:W3CDTF">2022-03-21T13:23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064A23859AC2742B92C1BBF73AACB70</vt:lpwstr>
  </property>
</Properties>
</file>